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30" r:id="rId1"/>
    <p:sldMasterId id="2147486285" r:id="rId2"/>
  </p:sldMasterIdLst>
  <p:notesMasterIdLst>
    <p:notesMasterId r:id="rId4"/>
  </p:notesMasterIdLst>
  <p:handoutMasterIdLst>
    <p:handoutMasterId r:id="rId5"/>
  </p:handoutMasterIdLst>
  <p:sldIdLst>
    <p:sldId id="1692" r:id="rId3"/>
  </p:sldIdLst>
  <p:sldSz cx="9144000" cy="6858000" type="screen4x3"/>
  <p:notesSz cx="6797675" cy="99266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9966"/>
    <a:srgbClr val="FF3300"/>
    <a:srgbClr val="6600FF"/>
    <a:srgbClr val="9933FF"/>
    <a:srgbClr val="FF33CC"/>
    <a:srgbClr val="FFFF00"/>
    <a:srgbClr val="000066"/>
    <a:srgbClr val="66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74" autoAdjust="0"/>
    <p:restoredTop sz="92627" autoAdjust="0"/>
  </p:normalViewPr>
  <p:slideViewPr>
    <p:cSldViewPr>
      <p:cViewPr varScale="1">
        <p:scale>
          <a:sx n="80" d="100"/>
          <a:sy n="80" d="100"/>
        </p:scale>
        <p:origin x="1478" y="53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dirty="0"/>
              <a:t>Men</a:t>
            </a:r>
            <a:endParaRPr lang="ja-JP" altLang="en-US" dirty="0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5851805080968656"/>
          <c:y val="0.11238301053705907"/>
          <c:w val="0.82889342841578773"/>
          <c:h val="0.67905658246388512"/>
        </c:manualLayout>
      </c:layout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20－29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Sheet1!$A$2:$A$72</c:f>
              <c:strCache>
                <c:ptCount val="71"/>
                <c:pt idx="0">
                  <c:v>1947</c:v>
                </c:pt>
                <c:pt idx="1">
                  <c:v>1948</c:v>
                </c:pt>
                <c:pt idx="2">
                  <c:v>1949</c:v>
                </c:pt>
                <c:pt idx="3">
                  <c:v>1950</c:v>
                </c:pt>
                <c:pt idx="4">
                  <c:v>1951</c:v>
                </c:pt>
                <c:pt idx="5">
                  <c:v>1952</c:v>
                </c:pt>
                <c:pt idx="6">
                  <c:v>1953</c:v>
                </c:pt>
                <c:pt idx="7">
                  <c:v>1954</c:v>
                </c:pt>
                <c:pt idx="8">
                  <c:v>1955</c:v>
                </c:pt>
                <c:pt idx="9">
                  <c:v>1956</c:v>
                </c:pt>
                <c:pt idx="10">
                  <c:v>1957</c:v>
                </c:pt>
                <c:pt idx="11">
                  <c:v>1958</c:v>
                </c:pt>
                <c:pt idx="12">
                  <c:v>1959</c:v>
                </c:pt>
                <c:pt idx="13">
                  <c:v>1960</c:v>
                </c:pt>
                <c:pt idx="14">
                  <c:v>1961</c:v>
                </c:pt>
                <c:pt idx="15">
                  <c:v>1962</c:v>
                </c:pt>
                <c:pt idx="16">
                  <c:v>1963</c:v>
                </c:pt>
                <c:pt idx="17">
                  <c:v>1964</c:v>
                </c:pt>
                <c:pt idx="18">
                  <c:v>1965</c:v>
                </c:pt>
                <c:pt idx="19">
                  <c:v>1966</c:v>
                </c:pt>
                <c:pt idx="20">
                  <c:v>1967</c:v>
                </c:pt>
                <c:pt idx="21">
                  <c:v>1968</c:v>
                </c:pt>
                <c:pt idx="22">
                  <c:v>1969</c:v>
                </c:pt>
                <c:pt idx="23">
                  <c:v>1970</c:v>
                </c:pt>
                <c:pt idx="24">
                  <c:v>1971</c:v>
                </c:pt>
                <c:pt idx="25">
                  <c:v>1972</c:v>
                </c:pt>
                <c:pt idx="26">
                  <c:v>1973</c:v>
                </c:pt>
                <c:pt idx="27">
                  <c:v>1974</c:v>
                </c:pt>
                <c:pt idx="28">
                  <c:v>1975</c:v>
                </c:pt>
                <c:pt idx="29">
                  <c:v>1976</c:v>
                </c:pt>
                <c:pt idx="30">
                  <c:v>1977</c:v>
                </c:pt>
                <c:pt idx="31">
                  <c:v>1978</c:v>
                </c:pt>
                <c:pt idx="32">
                  <c:v>1979</c:v>
                </c:pt>
                <c:pt idx="33">
                  <c:v>1980</c:v>
                </c:pt>
                <c:pt idx="34">
                  <c:v>1981</c:v>
                </c:pt>
                <c:pt idx="35">
                  <c:v>1982</c:v>
                </c:pt>
                <c:pt idx="36">
                  <c:v>1983</c:v>
                </c:pt>
                <c:pt idx="37">
                  <c:v>1984</c:v>
                </c:pt>
                <c:pt idx="38">
                  <c:v>1985</c:v>
                </c:pt>
                <c:pt idx="39">
                  <c:v>1986</c:v>
                </c:pt>
                <c:pt idx="40">
                  <c:v>1987</c:v>
                </c:pt>
                <c:pt idx="41">
                  <c:v>1988</c:v>
                </c:pt>
                <c:pt idx="42">
                  <c:v>1989</c:v>
                </c:pt>
                <c:pt idx="43">
                  <c:v>1990</c:v>
                </c:pt>
                <c:pt idx="44">
                  <c:v>1991</c:v>
                </c:pt>
                <c:pt idx="45">
                  <c:v>1992</c:v>
                </c:pt>
                <c:pt idx="46">
                  <c:v>1993</c:v>
                </c:pt>
                <c:pt idx="47">
                  <c:v>1994</c:v>
                </c:pt>
                <c:pt idx="48">
                  <c:v>1995</c:v>
                </c:pt>
                <c:pt idx="49">
                  <c:v>1996</c:v>
                </c:pt>
                <c:pt idx="50">
                  <c:v>1997</c:v>
                </c:pt>
                <c:pt idx="51">
                  <c:v>1998</c:v>
                </c:pt>
                <c:pt idx="52">
                  <c:v>1999</c:v>
                </c:pt>
                <c:pt idx="53">
                  <c:v>2000</c:v>
                </c:pt>
                <c:pt idx="54">
                  <c:v>2001</c:v>
                </c:pt>
                <c:pt idx="55">
                  <c:v>2002</c:v>
                </c:pt>
                <c:pt idx="56">
                  <c:v>2003</c:v>
                </c:pt>
                <c:pt idx="57">
                  <c:v>2004</c:v>
                </c:pt>
                <c:pt idx="58">
                  <c:v>2005</c:v>
                </c:pt>
                <c:pt idx="59">
                  <c:v>2006</c:v>
                </c:pt>
                <c:pt idx="60">
                  <c:v>2007</c:v>
                </c:pt>
                <c:pt idx="61">
                  <c:v>2008</c:v>
                </c:pt>
                <c:pt idx="62">
                  <c:v>2009</c:v>
                </c:pt>
                <c:pt idx="63">
                  <c:v>2010</c:v>
                </c:pt>
                <c:pt idx="64">
                  <c:v>2011</c:v>
                </c:pt>
                <c:pt idx="65">
                  <c:v>2012</c:v>
                </c:pt>
                <c:pt idx="66">
                  <c:v>2013</c:v>
                </c:pt>
                <c:pt idx="67">
                  <c:v>2014</c:v>
                </c:pt>
                <c:pt idx="68">
                  <c:v>2015</c:v>
                </c:pt>
                <c:pt idx="69">
                  <c:v>2016</c:v>
                </c:pt>
                <c:pt idx="70">
                  <c:v>2017</c:v>
                </c:pt>
              </c:strCache>
            </c:strRef>
          </c:cat>
          <c:val>
            <c:numRef>
              <c:f>Sheet1!$B$2:$B$72</c:f>
              <c:numCache>
                <c:formatCode>0.0_);[Red]\(0.0\)</c:formatCode>
                <c:ptCount val="71"/>
                <c:pt idx="0">
                  <c:v>21.443905241309761</c:v>
                </c:pt>
                <c:pt idx="1">
                  <c:v>21.343170742675461</c:v>
                </c:pt>
                <c:pt idx="2">
                  <c:v>21.113975979833029</c:v>
                </c:pt>
                <c:pt idx="3">
                  <c:v>21.28911667099905</c:v>
                </c:pt>
                <c:pt idx="4">
                  <c:v>21.277503360116878</c:v>
                </c:pt>
                <c:pt idx="5">
                  <c:v>21.11419854128604</c:v>
                </c:pt>
                <c:pt idx="6">
                  <c:v>21.176531292932715</c:v>
                </c:pt>
                <c:pt idx="7">
                  <c:v>21.131776110792309</c:v>
                </c:pt>
                <c:pt idx="8">
                  <c:v>21.152585974904252</c:v>
                </c:pt>
                <c:pt idx="9">
                  <c:v>21.060205244500075</c:v>
                </c:pt>
                <c:pt idx="10">
                  <c:v>21.239871307894401</c:v>
                </c:pt>
                <c:pt idx="11">
                  <c:v>21.233589778621901</c:v>
                </c:pt>
                <c:pt idx="12">
                  <c:v>21.192370595292669</c:v>
                </c:pt>
                <c:pt idx="13">
                  <c:v>21.328534318553519</c:v>
                </c:pt>
                <c:pt idx="14">
                  <c:v>21.131073027263394</c:v>
                </c:pt>
                <c:pt idx="15">
                  <c:v>21.132713440405745</c:v>
                </c:pt>
                <c:pt idx="16">
                  <c:v>21.132713440405745</c:v>
                </c:pt>
                <c:pt idx="17">
                  <c:v>21.129786277225026</c:v>
                </c:pt>
                <c:pt idx="18">
                  <c:v>21.296888218280923</c:v>
                </c:pt>
                <c:pt idx="19">
                  <c:v>21.046831955922862</c:v>
                </c:pt>
                <c:pt idx="20">
                  <c:v>21.298784921946783</c:v>
                </c:pt>
                <c:pt idx="21">
                  <c:v>21.284946285630834</c:v>
                </c:pt>
                <c:pt idx="22">
                  <c:v>21.098857605992656</c:v>
                </c:pt>
                <c:pt idx="23">
                  <c:v>21.364097633926182</c:v>
                </c:pt>
                <c:pt idx="24">
                  <c:v>21.389876331592554</c:v>
                </c:pt>
                <c:pt idx="25">
                  <c:v>21.626595817646521</c:v>
                </c:pt>
                <c:pt idx="26">
                  <c:v>21.158848693236596</c:v>
                </c:pt>
                <c:pt idx="28">
                  <c:v>21.254104703543611</c:v>
                </c:pt>
                <c:pt idx="29">
                  <c:v>21.339720150340892</c:v>
                </c:pt>
                <c:pt idx="30">
                  <c:v>21.156778313109061</c:v>
                </c:pt>
                <c:pt idx="31">
                  <c:v>21.505635761963955</c:v>
                </c:pt>
                <c:pt idx="32">
                  <c:v>21.367875108993015</c:v>
                </c:pt>
                <c:pt idx="33">
                  <c:v>21.192735348402163</c:v>
                </c:pt>
                <c:pt idx="34">
                  <c:v>21.731425475667947</c:v>
                </c:pt>
                <c:pt idx="35">
                  <c:v>21.509844478180444</c:v>
                </c:pt>
                <c:pt idx="36">
                  <c:v>21.80249542346181</c:v>
                </c:pt>
                <c:pt idx="37">
                  <c:v>21.701971160681499</c:v>
                </c:pt>
                <c:pt idx="38">
                  <c:v>21.643458386027408</c:v>
                </c:pt>
                <c:pt idx="39">
                  <c:v>21.72946846244529</c:v>
                </c:pt>
                <c:pt idx="40">
                  <c:v>21.740439108710795</c:v>
                </c:pt>
                <c:pt idx="41">
                  <c:v>21.730707390808515</c:v>
                </c:pt>
                <c:pt idx="42">
                  <c:v>21.91269775781744</c:v>
                </c:pt>
                <c:pt idx="43">
                  <c:v>22.169988904709886</c:v>
                </c:pt>
                <c:pt idx="44">
                  <c:v>22.106766299262386</c:v>
                </c:pt>
                <c:pt idx="45">
                  <c:v>22.136508231800814</c:v>
                </c:pt>
                <c:pt idx="46">
                  <c:v>22.154588747396712</c:v>
                </c:pt>
                <c:pt idx="47">
                  <c:v>21.832403057157183</c:v>
                </c:pt>
                <c:pt idx="48">
                  <c:v>22.253506631238263</c:v>
                </c:pt>
                <c:pt idx="49">
                  <c:v>21.798278430736055</c:v>
                </c:pt>
                <c:pt idx="50">
                  <c:v>22.279511311031531</c:v>
                </c:pt>
                <c:pt idx="51">
                  <c:v>22.355375746377813</c:v>
                </c:pt>
                <c:pt idx="52">
                  <c:v>22.452544576013686</c:v>
                </c:pt>
                <c:pt idx="53">
                  <c:v>22.400054717690914</c:v>
                </c:pt>
                <c:pt idx="54">
                  <c:v>22.371630868090676</c:v>
                </c:pt>
                <c:pt idx="55">
                  <c:v>22.476354567567576</c:v>
                </c:pt>
                <c:pt idx="56">
                  <c:v>22.126466263123699</c:v>
                </c:pt>
                <c:pt idx="57">
                  <c:v>22.530733275419745</c:v>
                </c:pt>
                <c:pt idx="58">
                  <c:v>22.502650388153619</c:v>
                </c:pt>
                <c:pt idx="59">
                  <c:v>22.337631429081419</c:v>
                </c:pt>
                <c:pt idx="60">
                  <c:v>22.25</c:v>
                </c:pt>
                <c:pt idx="61">
                  <c:v>22.08</c:v>
                </c:pt>
                <c:pt idx="62">
                  <c:v>22.18</c:v>
                </c:pt>
                <c:pt idx="63">
                  <c:v>22.33</c:v>
                </c:pt>
                <c:pt idx="64">
                  <c:v>22.66</c:v>
                </c:pt>
                <c:pt idx="65">
                  <c:v>22.3</c:v>
                </c:pt>
                <c:pt idx="66" formatCode="General">
                  <c:v>22.65</c:v>
                </c:pt>
                <c:pt idx="67" formatCode="General">
                  <c:v>22.36</c:v>
                </c:pt>
                <c:pt idx="68" formatCode="General">
                  <c:v>23.12</c:v>
                </c:pt>
                <c:pt idx="69" formatCode="General">
                  <c:v>22.9</c:v>
                </c:pt>
                <c:pt idx="70" formatCode="General">
                  <c:v>23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063-48D8-983C-369F4DB5CB77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30－39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Sheet1!$A$2:$A$72</c:f>
              <c:strCache>
                <c:ptCount val="71"/>
                <c:pt idx="0">
                  <c:v>1947</c:v>
                </c:pt>
                <c:pt idx="1">
                  <c:v>1948</c:v>
                </c:pt>
                <c:pt idx="2">
                  <c:v>1949</c:v>
                </c:pt>
                <c:pt idx="3">
                  <c:v>1950</c:v>
                </c:pt>
                <c:pt idx="4">
                  <c:v>1951</c:v>
                </c:pt>
                <c:pt idx="5">
                  <c:v>1952</c:v>
                </c:pt>
                <c:pt idx="6">
                  <c:v>1953</c:v>
                </c:pt>
                <c:pt idx="7">
                  <c:v>1954</c:v>
                </c:pt>
                <c:pt idx="8">
                  <c:v>1955</c:v>
                </c:pt>
                <c:pt idx="9">
                  <c:v>1956</c:v>
                </c:pt>
                <c:pt idx="10">
                  <c:v>1957</c:v>
                </c:pt>
                <c:pt idx="11">
                  <c:v>1958</c:v>
                </c:pt>
                <c:pt idx="12">
                  <c:v>1959</c:v>
                </c:pt>
                <c:pt idx="13">
                  <c:v>1960</c:v>
                </c:pt>
                <c:pt idx="14">
                  <c:v>1961</c:v>
                </c:pt>
                <c:pt idx="15">
                  <c:v>1962</c:v>
                </c:pt>
                <c:pt idx="16">
                  <c:v>1963</c:v>
                </c:pt>
                <c:pt idx="17">
                  <c:v>1964</c:v>
                </c:pt>
                <c:pt idx="18">
                  <c:v>1965</c:v>
                </c:pt>
                <c:pt idx="19">
                  <c:v>1966</c:v>
                </c:pt>
                <c:pt idx="20">
                  <c:v>1967</c:v>
                </c:pt>
                <c:pt idx="21">
                  <c:v>1968</c:v>
                </c:pt>
                <c:pt idx="22">
                  <c:v>1969</c:v>
                </c:pt>
                <c:pt idx="23">
                  <c:v>1970</c:v>
                </c:pt>
                <c:pt idx="24">
                  <c:v>1971</c:v>
                </c:pt>
                <c:pt idx="25">
                  <c:v>1972</c:v>
                </c:pt>
                <c:pt idx="26">
                  <c:v>1973</c:v>
                </c:pt>
                <c:pt idx="27">
                  <c:v>1974</c:v>
                </c:pt>
                <c:pt idx="28">
                  <c:v>1975</c:v>
                </c:pt>
                <c:pt idx="29">
                  <c:v>1976</c:v>
                </c:pt>
                <c:pt idx="30">
                  <c:v>1977</c:v>
                </c:pt>
                <c:pt idx="31">
                  <c:v>1978</c:v>
                </c:pt>
                <c:pt idx="32">
                  <c:v>1979</c:v>
                </c:pt>
                <c:pt idx="33">
                  <c:v>1980</c:v>
                </c:pt>
                <c:pt idx="34">
                  <c:v>1981</c:v>
                </c:pt>
                <c:pt idx="35">
                  <c:v>1982</c:v>
                </c:pt>
                <c:pt idx="36">
                  <c:v>1983</c:v>
                </c:pt>
                <c:pt idx="37">
                  <c:v>1984</c:v>
                </c:pt>
                <c:pt idx="38">
                  <c:v>1985</c:v>
                </c:pt>
                <c:pt idx="39">
                  <c:v>1986</c:v>
                </c:pt>
                <c:pt idx="40">
                  <c:v>1987</c:v>
                </c:pt>
                <c:pt idx="41">
                  <c:v>1988</c:v>
                </c:pt>
                <c:pt idx="42">
                  <c:v>1989</c:v>
                </c:pt>
                <c:pt idx="43">
                  <c:v>1990</c:v>
                </c:pt>
                <c:pt idx="44">
                  <c:v>1991</c:v>
                </c:pt>
                <c:pt idx="45">
                  <c:v>1992</c:v>
                </c:pt>
                <c:pt idx="46">
                  <c:v>1993</c:v>
                </c:pt>
                <c:pt idx="47">
                  <c:v>1994</c:v>
                </c:pt>
                <c:pt idx="48">
                  <c:v>1995</c:v>
                </c:pt>
                <c:pt idx="49">
                  <c:v>1996</c:v>
                </c:pt>
                <c:pt idx="50">
                  <c:v>1997</c:v>
                </c:pt>
                <c:pt idx="51">
                  <c:v>1998</c:v>
                </c:pt>
                <c:pt idx="52">
                  <c:v>1999</c:v>
                </c:pt>
                <c:pt idx="53">
                  <c:v>2000</c:v>
                </c:pt>
                <c:pt idx="54">
                  <c:v>2001</c:v>
                </c:pt>
                <c:pt idx="55">
                  <c:v>2002</c:v>
                </c:pt>
                <c:pt idx="56">
                  <c:v>2003</c:v>
                </c:pt>
                <c:pt idx="57">
                  <c:v>2004</c:v>
                </c:pt>
                <c:pt idx="58">
                  <c:v>2005</c:v>
                </c:pt>
                <c:pt idx="59">
                  <c:v>2006</c:v>
                </c:pt>
                <c:pt idx="60">
                  <c:v>2007</c:v>
                </c:pt>
                <c:pt idx="61">
                  <c:v>2008</c:v>
                </c:pt>
                <c:pt idx="62">
                  <c:v>2009</c:v>
                </c:pt>
                <c:pt idx="63">
                  <c:v>2010</c:v>
                </c:pt>
                <c:pt idx="64">
                  <c:v>2011</c:v>
                </c:pt>
                <c:pt idx="65">
                  <c:v>2012</c:v>
                </c:pt>
                <c:pt idx="66">
                  <c:v>2013</c:v>
                </c:pt>
                <c:pt idx="67">
                  <c:v>2014</c:v>
                </c:pt>
                <c:pt idx="68">
                  <c:v>2015</c:v>
                </c:pt>
                <c:pt idx="69">
                  <c:v>2016</c:v>
                </c:pt>
                <c:pt idx="70">
                  <c:v>2017</c:v>
                </c:pt>
              </c:strCache>
            </c:strRef>
          </c:cat>
          <c:val>
            <c:numRef>
              <c:f>Sheet1!$C$2:$C$72</c:f>
              <c:numCache>
                <c:formatCode>0.0_);[Red]\(0.0\)</c:formatCode>
                <c:ptCount val="71"/>
                <c:pt idx="0">
                  <c:v>21.457544687287498</c:v>
                </c:pt>
                <c:pt idx="1">
                  <c:v>21.515625</c:v>
                </c:pt>
                <c:pt idx="2">
                  <c:v>21.232802344636866</c:v>
                </c:pt>
                <c:pt idx="3">
                  <c:v>21.516892258705507</c:v>
                </c:pt>
                <c:pt idx="4">
                  <c:v>21.455537116293517</c:v>
                </c:pt>
                <c:pt idx="5">
                  <c:v>21.331314719383546</c:v>
                </c:pt>
                <c:pt idx="6">
                  <c:v>21.436580444751858</c:v>
                </c:pt>
                <c:pt idx="7">
                  <c:v>21.268524449474814</c:v>
                </c:pt>
                <c:pt idx="8">
                  <c:v>21.398292860768986</c:v>
                </c:pt>
                <c:pt idx="9">
                  <c:v>21.305215055992406</c:v>
                </c:pt>
                <c:pt idx="10">
                  <c:v>21.412700825644261</c:v>
                </c:pt>
                <c:pt idx="11">
                  <c:v>21.512509040320982</c:v>
                </c:pt>
                <c:pt idx="12">
                  <c:v>21.50483148534585</c:v>
                </c:pt>
                <c:pt idx="13">
                  <c:v>21.521109586953205</c:v>
                </c:pt>
                <c:pt idx="14">
                  <c:v>21.493952053188739</c:v>
                </c:pt>
                <c:pt idx="15">
                  <c:v>21.627338044598162</c:v>
                </c:pt>
                <c:pt idx="16">
                  <c:v>21.608598849765826</c:v>
                </c:pt>
                <c:pt idx="17">
                  <c:v>21.842930606427835</c:v>
                </c:pt>
                <c:pt idx="18">
                  <c:v>21.812310620298447</c:v>
                </c:pt>
                <c:pt idx="19">
                  <c:v>21.901982973582331</c:v>
                </c:pt>
                <c:pt idx="20">
                  <c:v>21.864756201365534</c:v>
                </c:pt>
                <c:pt idx="21">
                  <c:v>22.162003074266636</c:v>
                </c:pt>
                <c:pt idx="22">
                  <c:v>22.043778553252981</c:v>
                </c:pt>
                <c:pt idx="23">
                  <c:v>22.280204621758365</c:v>
                </c:pt>
                <c:pt idx="24">
                  <c:v>22.452301999231068</c:v>
                </c:pt>
                <c:pt idx="25">
                  <c:v>22.482207820142339</c:v>
                </c:pt>
                <c:pt idx="26">
                  <c:v>22.656130620346797</c:v>
                </c:pt>
                <c:pt idx="28">
                  <c:v>22.772641820260866</c:v>
                </c:pt>
                <c:pt idx="29">
                  <c:v>22.579244463742945</c:v>
                </c:pt>
                <c:pt idx="30">
                  <c:v>22.351658273191497</c:v>
                </c:pt>
                <c:pt idx="31">
                  <c:v>22.580806899699127</c:v>
                </c:pt>
                <c:pt idx="32">
                  <c:v>22.499637102627378</c:v>
                </c:pt>
                <c:pt idx="33">
                  <c:v>22.61753779829143</c:v>
                </c:pt>
                <c:pt idx="34">
                  <c:v>22.581291744127505</c:v>
                </c:pt>
                <c:pt idx="35">
                  <c:v>22.688427932470336</c:v>
                </c:pt>
                <c:pt idx="36">
                  <c:v>22.760226755041444</c:v>
                </c:pt>
                <c:pt idx="37">
                  <c:v>22.661264297751799</c:v>
                </c:pt>
                <c:pt idx="38">
                  <c:v>22.72138145999277</c:v>
                </c:pt>
                <c:pt idx="39">
                  <c:v>22.746598639455783</c:v>
                </c:pt>
                <c:pt idx="40">
                  <c:v>22.844648233211228</c:v>
                </c:pt>
                <c:pt idx="41">
                  <c:v>22.858350430134987</c:v>
                </c:pt>
                <c:pt idx="42">
                  <c:v>22.758306781975424</c:v>
                </c:pt>
                <c:pt idx="43">
                  <c:v>22.944733410659076</c:v>
                </c:pt>
                <c:pt idx="44">
                  <c:v>23.073421798956623</c:v>
                </c:pt>
                <c:pt idx="45">
                  <c:v>23.146335308603302</c:v>
                </c:pt>
                <c:pt idx="46">
                  <c:v>23.487832228977954</c:v>
                </c:pt>
                <c:pt idx="47">
                  <c:v>23.059896354741294</c:v>
                </c:pt>
                <c:pt idx="48">
                  <c:v>23.197979566446335</c:v>
                </c:pt>
                <c:pt idx="49">
                  <c:v>23.232500369372595</c:v>
                </c:pt>
                <c:pt idx="50">
                  <c:v>23.246875619916683</c:v>
                </c:pt>
                <c:pt idx="51">
                  <c:v>23.611381372198771</c:v>
                </c:pt>
                <c:pt idx="52">
                  <c:v>23.597004206422486</c:v>
                </c:pt>
                <c:pt idx="53">
                  <c:v>23.432915205831709</c:v>
                </c:pt>
                <c:pt idx="54">
                  <c:v>23.774381123141389</c:v>
                </c:pt>
                <c:pt idx="55">
                  <c:v>23.761581631133286</c:v>
                </c:pt>
                <c:pt idx="56">
                  <c:v>23.789413642371755</c:v>
                </c:pt>
                <c:pt idx="57">
                  <c:v>23.424824229313138</c:v>
                </c:pt>
                <c:pt idx="58">
                  <c:v>23.296439380355462</c:v>
                </c:pt>
                <c:pt idx="59">
                  <c:v>23.997581860687401</c:v>
                </c:pt>
                <c:pt idx="60">
                  <c:v>23.79</c:v>
                </c:pt>
                <c:pt idx="61">
                  <c:v>23.65</c:v>
                </c:pt>
                <c:pt idx="62">
                  <c:v>24.06</c:v>
                </c:pt>
                <c:pt idx="63">
                  <c:v>23.64</c:v>
                </c:pt>
                <c:pt idx="64">
                  <c:v>23.81</c:v>
                </c:pt>
                <c:pt idx="65">
                  <c:v>23.6</c:v>
                </c:pt>
                <c:pt idx="66" formatCode="General">
                  <c:v>23.4</c:v>
                </c:pt>
                <c:pt idx="67" formatCode="General">
                  <c:v>23.48</c:v>
                </c:pt>
                <c:pt idx="68" formatCode="General">
                  <c:v>24.02</c:v>
                </c:pt>
                <c:pt idx="69" formatCode="General">
                  <c:v>23.5</c:v>
                </c:pt>
                <c:pt idx="70" formatCode="General">
                  <c:v>24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063-48D8-983C-369F4DB5CB77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40－49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Sheet1!$A$2:$A$72</c:f>
              <c:strCache>
                <c:ptCount val="71"/>
                <c:pt idx="0">
                  <c:v>1947</c:v>
                </c:pt>
                <c:pt idx="1">
                  <c:v>1948</c:v>
                </c:pt>
                <c:pt idx="2">
                  <c:v>1949</c:v>
                </c:pt>
                <c:pt idx="3">
                  <c:v>1950</c:v>
                </c:pt>
                <c:pt idx="4">
                  <c:v>1951</c:v>
                </c:pt>
                <c:pt idx="5">
                  <c:v>1952</c:v>
                </c:pt>
                <c:pt idx="6">
                  <c:v>1953</c:v>
                </c:pt>
                <c:pt idx="7">
                  <c:v>1954</c:v>
                </c:pt>
                <c:pt idx="8">
                  <c:v>1955</c:v>
                </c:pt>
                <c:pt idx="9">
                  <c:v>1956</c:v>
                </c:pt>
                <c:pt idx="10">
                  <c:v>1957</c:v>
                </c:pt>
                <c:pt idx="11">
                  <c:v>1958</c:v>
                </c:pt>
                <c:pt idx="12">
                  <c:v>1959</c:v>
                </c:pt>
                <c:pt idx="13">
                  <c:v>1960</c:v>
                </c:pt>
                <c:pt idx="14">
                  <c:v>1961</c:v>
                </c:pt>
                <c:pt idx="15">
                  <c:v>1962</c:v>
                </c:pt>
                <c:pt idx="16">
                  <c:v>1963</c:v>
                </c:pt>
                <c:pt idx="17">
                  <c:v>1964</c:v>
                </c:pt>
                <c:pt idx="18">
                  <c:v>1965</c:v>
                </c:pt>
                <c:pt idx="19">
                  <c:v>1966</c:v>
                </c:pt>
                <c:pt idx="20">
                  <c:v>1967</c:v>
                </c:pt>
                <c:pt idx="21">
                  <c:v>1968</c:v>
                </c:pt>
                <c:pt idx="22">
                  <c:v>1969</c:v>
                </c:pt>
                <c:pt idx="23">
                  <c:v>1970</c:v>
                </c:pt>
                <c:pt idx="24">
                  <c:v>1971</c:v>
                </c:pt>
                <c:pt idx="25">
                  <c:v>1972</c:v>
                </c:pt>
                <c:pt idx="26">
                  <c:v>1973</c:v>
                </c:pt>
                <c:pt idx="27">
                  <c:v>1974</c:v>
                </c:pt>
                <c:pt idx="28">
                  <c:v>1975</c:v>
                </c:pt>
                <c:pt idx="29">
                  <c:v>1976</c:v>
                </c:pt>
                <c:pt idx="30">
                  <c:v>1977</c:v>
                </c:pt>
                <c:pt idx="31">
                  <c:v>1978</c:v>
                </c:pt>
                <c:pt idx="32">
                  <c:v>1979</c:v>
                </c:pt>
                <c:pt idx="33">
                  <c:v>1980</c:v>
                </c:pt>
                <c:pt idx="34">
                  <c:v>1981</c:v>
                </c:pt>
                <c:pt idx="35">
                  <c:v>1982</c:v>
                </c:pt>
                <c:pt idx="36">
                  <c:v>1983</c:v>
                </c:pt>
                <c:pt idx="37">
                  <c:v>1984</c:v>
                </c:pt>
                <c:pt idx="38">
                  <c:v>1985</c:v>
                </c:pt>
                <c:pt idx="39">
                  <c:v>1986</c:v>
                </c:pt>
                <c:pt idx="40">
                  <c:v>1987</c:v>
                </c:pt>
                <c:pt idx="41">
                  <c:v>1988</c:v>
                </c:pt>
                <c:pt idx="42">
                  <c:v>1989</c:v>
                </c:pt>
                <c:pt idx="43">
                  <c:v>1990</c:v>
                </c:pt>
                <c:pt idx="44">
                  <c:v>1991</c:v>
                </c:pt>
                <c:pt idx="45">
                  <c:v>1992</c:v>
                </c:pt>
                <c:pt idx="46">
                  <c:v>1993</c:v>
                </c:pt>
                <c:pt idx="47">
                  <c:v>1994</c:v>
                </c:pt>
                <c:pt idx="48">
                  <c:v>1995</c:v>
                </c:pt>
                <c:pt idx="49">
                  <c:v>1996</c:v>
                </c:pt>
                <c:pt idx="50">
                  <c:v>1997</c:v>
                </c:pt>
                <c:pt idx="51">
                  <c:v>1998</c:v>
                </c:pt>
                <c:pt idx="52">
                  <c:v>1999</c:v>
                </c:pt>
                <c:pt idx="53">
                  <c:v>2000</c:v>
                </c:pt>
                <c:pt idx="54">
                  <c:v>2001</c:v>
                </c:pt>
                <c:pt idx="55">
                  <c:v>2002</c:v>
                </c:pt>
                <c:pt idx="56">
                  <c:v>2003</c:v>
                </c:pt>
                <c:pt idx="57">
                  <c:v>2004</c:v>
                </c:pt>
                <c:pt idx="58">
                  <c:v>2005</c:v>
                </c:pt>
                <c:pt idx="59">
                  <c:v>2006</c:v>
                </c:pt>
                <c:pt idx="60">
                  <c:v>2007</c:v>
                </c:pt>
                <c:pt idx="61">
                  <c:v>2008</c:v>
                </c:pt>
                <c:pt idx="62">
                  <c:v>2009</c:v>
                </c:pt>
                <c:pt idx="63">
                  <c:v>2010</c:v>
                </c:pt>
                <c:pt idx="64">
                  <c:v>2011</c:v>
                </c:pt>
                <c:pt idx="65">
                  <c:v>2012</c:v>
                </c:pt>
                <c:pt idx="66">
                  <c:v>2013</c:v>
                </c:pt>
                <c:pt idx="67">
                  <c:v>2014</c:v>
                </c:pt>
                <c:pt idx="68">
                  <c:v>2015</c:v>
                </c:pt>
                <c:pt idx="69">
                  <c:v>2016</c:v>
                </c:pt>
                <c:pt idx="70">
                  <c:v>2017</c:v>
                </c:pt>
              </c:strCache>
            </c:strRef>
          </c:cat>
          <c:val>
            <c:numRef>
              <c:f>Sheet1!$D$2:$D$72</c:f>
              <c:numCache>
                <c:formatCode>0.0_);[Red]\(0.0\)</c:formatCode>
                <c:ptCount val="71"/>
                <c:pt idx="0">
                  <c:v>21.532068408687635</c:v>
                </c:pt>
                <c:pt idx="1">
                  <c:v>21.604096212779726</c:v>
                </c:pt>
                <c:pt idx="2">
                  <c:v>21.356775482453354</c:v>
                </c:pt>
                <c:pt idx="3">
                  <c:v>21.530600514127041</c:v>
                </c:pt>
                <c:pt idx="4">
                  <c:v>21.622375671339885</c:v>
                </c:pt>
                <c:pt idx="5">
                  <c:v>21.525959169686118</c:v>
                </c:pt>
                <c:pt idx="6">
                  <c:v>21.675248002431072</c:v>
                </c:pt>
                <c:pt idx="7">
                  <c:v>21.527234160753522</c:v>
                </c:pt>
                <c:pt idx="8">
                  <c:v>21.458721992952306</c:v>
                </c:pt>
                <c:pt idx="9">
                  <c:v>21.717828405600471</c:v>
                </c:pt>
                <c:pt idx="10">
                  <c:v>21.64423433814364</c:v>
                </c:pt>
                <c:pt idx="11">
                  <c:v>21.550367040688734</c:v>
                </c:pt>
                <c:pt idx="12">
                  <c:v>21.816324383477632</c:v>
                </c:pt>
                <c:pt idx="13">
                  <c:v>21.941480780084174</c:v>
                </c:pt>
                <c:pt idx="14">
                  <c:v>21.874965905601773</c:v>
                </c:pt>
                <c:pt idx="15">
                  <c:v>21.839850156733725</c:v>
                </c:pt>
                <c:pt idx="16">
                  <c:v>21.9330169544162</c:v>
                </c:pt>
                <c:pt idx="17">
                  <c:v>22.028471123799239</c:v>
                </c:pt>
                <c:pt idx="18">
                  <c:v>22.01689749623857</c:v>
                </c:pt>
                <c:pt idx="19">
                  <c:v>22.01194648717853</c:v>
                </c:pt>
                <c:pt idx="20">
                  <c:v>22.119565572500861</c:v>
                </c:pt>
                <c:pt idx="21">
                  <c:v>22.190685962160572</c:v>
                </c:pt>
                <c:pt idx="22">
                  <c:v>22.057224871944186</c:v>
                </c:pt>
                <c:pt idx="23">
                  <c:v>22.31367169638775</c:v>
                </c:pt>
                <c:pt idx="24">
                  <c:v>22.526579642932681</c:v>
                </c:pt>
                <c:pt idx="25">
                  <c:v>22.477882070385256</c:v>
                </c:pt>
                <c:pt idx="26">
                  <c:v>22.439589255955301</c:v>
                </c:pt>
                <c:pt idx="28">
                  <c:v>22.928770876722183</c:v>
                </c:pt>
                <c:pt idx="29">
                  <c:v>22.703842540352216</c:v>
                </c:pt>
                <c:pt idx="30">
                  <c:v>22.675959408146134</c:v>
                </c:pt>
                <c:pt idx="31">
                  <c:v>22.977802461831942</c:v>
                </c:pt>
                <c:pt idx="32">
                  <c:v>22.87480842347945</c:v>
                </c:pt>
                <c:pt idx="33">
                  <c:v>23.090578143021919</c:v>
                </c:pt>
                <c:pt idx="34">
                  <c:v>23.17480591100049</c:v>
                </c:pt>
                <c:pt idx="35">
                  <c:v>23.014574657941701</c:v>
                </c:pt>
                <c:pt idx="36">
                  <c:v>23.312016656751936</c:v>
                </c:pt>
                <c:pt idx="37">
                  <c:v>23.264006839914362</c:v>
                </c:pt>
                <c:pt idx="38">
                  <c:v>23.123055895937409</c:v>
                </c:pt>
                <c:pt idx="39">
                  <c:v>23.270336506739557</c:v>
                </c:pt>
                <c:pt idx="40">
                  <c:v>23.166370773921468</c:v>
                </c:pt>
                <c:pt idx="41">
                  <c:v>23.080272898824212</c:v>
                </c:pt>
                <c:pt idx="42">
                  <c:v>23.113905325443785</c:v>
                </c:pt>
                <c:pt idx="43">
                  <c:v>23.366713664940828</c:v>
                </c:pt>
                <c:pt idx="44">
                  <c:v>23.282685994294848</c:v>
                </c:pt>
                <c:pt idx="45">
                  <c:v>23.434489818217369</c:v>
                </c:pt>
                <c:pt idx="46">
                  <c:v>23.231116421080575</c:v>
                </c:pt>
                <c:pt idx="47">
                  <c:v>23.396978091823541</c:v>
                </c:pt>
                <c:pt idx="48">
                  <c:v>23.589582414728977</c:v>
                </c:pt>
                <c:pt idx="49">
                  <c:v>23.3843537414966</c:v>
                </c:pt>
                <c:pt idx="50">
                  <c:v>23.540855756057354</c:v>
                </c:pt>
                <c:pt idx="51">
                  <c:v>23.724717024496826</c:v>
                </c:pt>
                <c:pt idx="52">
                  <c:v>23.79416442884062</c:v>
                </c:pt>
                <c:pt idx="53">
                  <c:v>23.584375912490732</c:v>
                </c:pt>
                <c:pt idx="54">
                  <c:v>23.808690171912748</c:v>
                </c:pt>
                <c:pt idx="55">
                  <c:v>23.898830841284198</c:v>
                </c:pt>
                <c:pt idx="56">
                  <c:v>23.957437230824045</c:v>
                </c:pt>
                <c:pt idx="57">
                  <c:v>24.07343119751372</c:v>
                </c:pt>
                <c:pt idx="58">
                  <c:v>24.022950783196865</c:v>
                </c:pt>
                <c:pt idx="59">
                  <c:v>24.060999639602819</c:v>
                </c:pt>
                <c:pt idx="60">
                  <c:v>23.93</c:v>
                </c:pt>
                <c:pt idx="61">
                  <c:v>24.18</c:v>
                </c:pt>
                <c:pt idx="62">
                  <c:v>24.19</c:v>
                </c:pt>
                <c:pt idx="63">
                  <c:v>24.18</c:v>
                </c:pt>
                <c:pt idx="64">
                  <c:v>24.16</c:v>
                </c:pt>
                <c:pt idx="65">
                  <c:v>24.1</c:v>
                </c:pt>
                <c:pt idx="66" formatCode="General">
                  <c:v>24.04</c:v>
                </c:pt>
                <c:pt idx="67" formatCode="General">
                  <c:v>24.02</c:v>
                </c:pt>
                <c:pt idx="68" formatCode="General">
                  <c:v>24.18</c:v>
                </c:pt>
                <c:pt idx="69" formatCode="General">
                  <c:v>24.1</c:v>
                </c:pt>
                <c:pt idx="70" formatCode="General">
                  <c:v>24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063-48D8-983C-369F4DB5CB77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50－59</c:v>
                </c:pt>
              </c:strCache>
            </c:strRef>
          </c:tx>
          <c:spPr>
            <a:ln w="12700" cap="rnd">
              <a:solidFill>
                <a:schemeClr val="accent4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Sheet1!$A$2:$A$72</c:f>
              <c:strCache>
                <c:ptCount val="71"/>
                <c:pt idx="0">
                  <c:v>1947</c:v>
                </c:pt>
                <c:pt idx="1">
                  <c:v>1948</c:v>
                </c:pt>
                <c:pt idx="2">
                  <c:v>1949</c:v>
                </c:pt>
                <c:pt idx="3">
                  <c:v>1950</c:v>
                </c:pt>
                <c:pt idx="4">
                  <c:v>1951</c:v>
                </c:pt>
                <c:pt idx="5">
                  <c:v>1952</c:v>
                </c:pt>
                <c:pt idx="6">
                  <c:v>1953</c:v>
                </c:pt>
                <c:pt idx="7">
                  <c:v>1954</c:v>
                </c:pt>
                <c:pt idx="8">
                  <c:v>1955</c:v>
                </c:pt>
                <c:pt idx="9">
                  <c:v>1956</c:v>
                </c:pt>
                <c:pt idx="10">
                  <c:v>1957</c:v>
                </c:pt>
                <c:pt idx="11">
                  <c:v>1958</c:v>
                </c:pt>
                <c:pt idx="12">
                  <c:v>1959</c:v>
                </c:pt>
                <c:pt idx="13">
                  <c:v>1960</c:v>
                </c:pt>
                <c:pt idx="14">
                  <c:v>1961</c:v>
                </c:pt>
                <c:pt idx="15">
                  <c:v>1962</c:v>
                </c:pt>
                <c:pt idx="16">
                  <c:v>1963</c:v>
                </c:pt>
                <c:pt idx="17">
                  <c:v>1964</c:v>
                </c:pt>
                <c:pt idx="18">
                  <c:v>1965</c:v>
                </c:pt>
                <c:pt idx="19">
                  <c:v>1966</c:v>
                </c:pt>
                <c:pt idx="20">
                  <c:v>1967</c:v>
                </c:pt>
                <c:pt idx="21">
                  <c:v>1968</c:v>
                </c:pt>
                <c:pt idx="22">
                  <c:v>1969</c:v>
                </c:pt>
                <c:pt idx="23">
                  <c:v>1970</c:v>
                </c:pt>
                <c:pt idx="24">
                  <c:v>1971</c:v>
                </c:pt>
                <c:pt idx="25">
                  <c:v>1972</c:v>
                </c:pt>
                <c:pt idx="26">
                  <c:v>1973</c:v>
                </c:pt>
                <c:pt idx="27">
                  <c:v>1974</c:v>
                </c:pt>
                <c:pt idx="28">
                  <c:v>1975</c:v>
                </c:pt>
                <c:pt idx="29">
                  <c:v>1976</c:v>
                </c:pt>
                <c:pt idx="30">
                  <c:v>1977</c:v>
                </c:pt>
                <c:pt idx="31">
                  <c:v>1978</c:v>
                </c:pt>
                <c:pt idx="32">
                  <c:v>1979</c:v>
                </c:pt>
                <c:pt idx="33">
                  <c:v>1980</c:v>
                </c:pt>
                <c:pt idx="34">
                  <c:v>1981</c:v>
                </c:pt>
                <c:pt idx="35">
                  <c:v>1982</c:v>
                </c:pt>
                <c:pt idx="36">
                  <c:v>1983</c:v>
                </c:pt>
                <c:pt idx="37">
                  <c:v>1984</c:v>
                </c:pt>
                <c:pt idx="38">
                  <c:v>1985</c:v>
                </c:pt>
                <c:pt idx="39">
                  <c:v>1986</c:v>
                </c:pt>
                <c:pt idx="40">
                  <c:v>1987</c:v>
                </c:pt>
                <c:pt idx="41">
                  <c:v>1988</c:v>
                </c:pt>
                <c:pt idx="42">
                  <c:v>1989</c:v>
                </c:pt>
                <c:pt idx="43">
                  <c:v>1990</c:v>
                </c:pt>
                <c:pt idx="44">
                  <c:v>1991</c:v>
                </c:pt>
                <c:pt idx="45">
                  <c:v>1992</c:v>
                </c:pt>
                <c:pt idx="46">
                  <c:v>1993</c:v>
                </c:pt>
                <c:pt idx="47">
                  <c:v>1994</c:v>
                </c:pt>
                <c:pt idx="48">
                  <c:v>1995</c:v>
                </c:pt>
                <c:pt idx="49">
                  <c:v>1996</c:v>
                </c:pt>
                <c:pt idx="50">
                  <c:v>1997</c:v>
                </c:pt>
                <c:pt idx="51">
                  <c:v>1998</c:v>
                </c:pt>
                <c:pt idx="52">
                  <c:v>1999</c:v>
                </c:pt>
                <c:pt idx="53">
                  <c:v>2000</c:v>
                </c:pt>
                <c:pt idx="54">
                  <c:v>2001</c:v>
                </c:pt>
                <c:pt idx="55">
                  <c:v>2002</c:v>
                </c:pt>
                <c:pt idx="56">
                  <c:v>2003</c:v>
                </c:pt>
                <c:pt idx="57">
                  <c:v>2004</c:v>
                </c:pt>
                <c:pt idx="58">
                  <c:v>2005</c:v>
                </c:pt>
                <c:pt idx="59">
                  <c:v>2006</c:v>
                </c:pt>
                <c:pt idx="60">
                  <c:v>2007</c:v>
                </c:pt>
                <c:pt idx="61">
                  <c:v>2008</c:v>
                </c:pt>
                <c:pt idx="62">
                  <c:v>2009</c:v>
                </c:pt>
                <c:pt idx="63">
                  <c:v>2010</c:v>
                </c:pt>
                <c:pt idx="64">
                  <c:v>2011</c:v>
                </c:pt>
                <c:pt idx="65">
                  <c:v>2012</c:v>
                </c:pt>
                <c:pt idx="66">
                  <c:v>2013</c:v>
                </c:pt>
                <c:pt idx="67">
                  <c:v>2014</c:v>
                </c:pt>
                <c:pt idx="68">
                  <c:v>2015</c:v>
                </c:pt>
                <c:pt idx="69">
                  <c:v>2016</c:v>
                </c:pt>
                <c:pt idx="70">
                  <c:v>2017</c:v>
                </c:pt>
              </c:strCache>
            </c:strRef>
          </c:cat>
          <c:val>
            <c:numRef>
              <c:f>Sheet1!$E$2:$E$72</c:f>
              <c:numCache>
                <c:formatCode>0.0_);[Red]\(0.0\)</c:formatCode>
                <c:ptCount val="71"/>
                <c:pt idx="0">
                  <c:v>21.133135545260167</c:v>
                </c:pt>
                <c:pt idx="1">
                  <c:v>21.43714005705807</c:v>
                </c:pt>
                <c:pt idx="2">
                  <c:v>21.293020912068531</c:v>
                </c:pt>
                <c:pt idx="3">
                  <c:v>21.340645536455796</c:v>
                </c:pt>
                <c:pt idx="4">
                  <c:v>21.537426046671516</c:v>
                </c:pt>
                <c:pt idx="5">
                  <c:v>21.477187114972825</c:v>
                </c:pt>
                <c:pt idx="6">
                  <c:v>21.564503317185597</c:v>
                </c:pt>
                <c:pt idx="7">
                  <c:v>21.368757037915184</c:v>
                </c:pt>
                <c:pt idx="8">
                  <c:v>21.379754284852421</c:v>
                </c:pt>
                <c:pt idx="9">
                  <c:v>21.472510778938357</c:v>
                </c:pt>
                <c:pt idx="10">
                  <c:v>21.631331124936423</c:v>
                </c:pt>
                <c:pt idx="11">
                  <c:v>21.494889987958882</c:v>
                </c:pt>
                <c:pt idx="12">
                  <c:v>21.593778696051423</c:v>
                </c:pt>
                <c:pt idx="13">
                  <c:v>21.71074129793546</c:v>
                </c:pt>
                <c:pt idx="14">
                  <c:v>21.613069103279141</c:v>
                </c:pt>
                <c:pt idx="15">
                  <c:v>21.697248122179229</c:v>
                </c:pt>
                <c:pt idx="16">
                  <c:v>22.008609378273615</c:v>
                </c:pt>
                <c:pt idx="17">
                  <c:v>21.87809026541672</c:v>
                </c:pt>
                <c:pt idx="18">
                  <c:v>21.992761437574089</c:v>
                </c:pt>
                <c:pt idx="19">
                  <c:v>21.894280887545911</c:v>
                </c:pt>
                <c:pt idx="20">
                  <c:v>22.063127913993409</c:v>
                </c:pt>
                <c:pt idx="21">
                  <c:v>22.075081186675966</c:v>
                </c:pt>
                <c:pt idx="22">
                  <c:v>22.093468284383476</c:v>
                </c:pt>
                <c:pt idx="23">
                  <c:v>22.164415611539575</c:v>
                </c:pt>
                <c:pt idx="24">
                  <c:v>22.0817641690995</c:v>
                </c:pt>
                <c:pt idx="25">
                  <c:v>22.422328698728624</c:v>
                </c:pt>
                <c:pt idx="26">
                  <c:v>22.220337811948419</c:v>
                </c:pt>
                <c:pt idx="28">
                  <c:v>22.25994367501254</c:v>
                </c:pt>
                <c:pt idx="29">
                  <c:v>22.558008653159416</c:v>
                </c:pt>
                <c:pt idx="30">
                  <c:v>22.54056434637565</c:v>
                </c:pt>
                <c:pt idx="31">
                  <c:v>22.579095225600224</c:v>
                </c:pt>
                <c:pt idx="32">
                  <c:v>22.582407576033507</c:v>
                </c:pt>
                <c:pt idx="33">
                  <c:v>22.617626104824797</c:v>
                </c:pt>
                <c:pt idx="34">
                  <c:v>22.735768578247658</c:v>
                </c:pt>
                <c:pt idx="35">
                  <c:v>22.814317777503938</c:v>
                </c:pt>
                <c:pt idx="36">
                  <c:v>22.899103029114794</c:v>
                </c:pt>
                <c:pt idx="37">
                  <c:v>22.872226457114959</c:v>
                </c:pt>
                <c:pt idx="38">
                  <c:v>22.844032652142779</c:v>
                </c:pt>
                <c:pt idx="39">
                  <c:v>23.090993606964123</c:v>
                </c:pt>
                <c:pt idx="40">
                  <c:v>23.100591715976329</c:v>
                </c:pt>
                <c:pt idx="41">
                  <c:v>23.296264058284109</c:v>
                </c:pt>
                <c:pt idx="42">
                  <c:v>23.287304968820884</c:v>
                </c:pt>
                <c:pt idx="43">
                  <c:v>23.27964551551775</c:v>
                </c:pt>
                <c:pt idx="44">
                  <c:v>23.49222381206221</c:v>
                </c:pt>
                <c:pt idx="45">
                  <c:v>23.598931085099178</c:v>
                </c:pt>
                <c:pt idx="46">
                  <c:v>23.477800311850466</c:v>
                </c:pt>
                <c:pt idx="47">
                  <c:v>23.466154229912881</c:v>
                </c:pt>
                <c:pt idx="48">
                  <c:v>23.420711456834848</c:v>
                </c:pt>
                <c:pt idx="49">
                  <c:v>23.360881542699723</c:v>
                </c:pt>
                <c:pt idx="50">
                  <c:v>23.332591043880313</c:v>
                </c:pt>
                <c:pt idx="51">
                  <c:v>23.621544162612611</c:v>
                </c:pt>
                <c:pt idx="52">
                  <c:v>23.528134878128995</c:v>
                </c:pt>
                <c:pt idx="53">
                  <c:v>23.585034820784767</c:v>
                </c:pt>
                <c:pt idx="54">
                  <c:v>23.78500957916825</c:v>
                </c:pt>
                <c:pt idx="55">
                  <c:v>23.821212029060433</c:v>
                </c:pt>
                <c:pt idx="56">
                  <c:v>23.857414478952624</c:v>
                </c:pt>
                <c:pt idx="57">
                  <c:v>23.702383604366226</c:v>
                </c:pt>
                <c:pt idx="58">
                  <c:v>23.766395601289808</c:v>
                </c:pt>
                <c:pt idx="59">
                  <c:v>23.794815802758833</c:v>
                </c:pt>
                <c:pt idx="60">
                  <c:v>23.81</c:v>
                </c:pt>
                <c:pt idx="61">
                  <c:v>23.88</c:v>
                </c:pt>
                <c:pt idx="62">
                  <c:v>23.7</c:v>
                </c:pt>
                <c:pt idx="63">
                  <c:v>24.13</c:v>
                </c:pt>
                <c:pt idx="64">
                  <c:v>23.99</c:v>
                </c:pt>
                <c:pt idx="65">
                  <c:v>23.9</c:v>
                </c:pt>
                <c:pt idx="66" formatCode="General">
                  <c:v>23.85</c:v>
                </c:pt>
                <c:pt idx="67" formatCode="General">
                  <c:v>23.94</c:v>
                </c:pt>
                <c:pt idx="68" formatCode="General">
                  <c:v>23.78</c:v>
                </c:pt>
                <c:pt idx="69" formatCode="General">
                  <c:v>24.1</c:v>
                </c:pt>
                <c:pt idx="70" formatCode="General">
                  <c:v>23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2063-48D8-983C-369F4DB5CB77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60－69</c:v>
                </c:pt>
              </c:strCache>
            </c:strRef>
          </c:tx>
          <c:spPr>
            <a:ln w="12700" cap="rnd">
              <a:solidFill>
                <a:schemeClr val="accent4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cat>
            <c:strRef>
              <c:f>Sheet1!$A$2:$A$72</c:f>
              <c:strCache>
                <c:ptCount val="71"/>
                <c:pt idx="0">
                  <c:v>1947</c:v>
                </c:pt>
                <c:pt idx="1">
                  <c:v>1948</c:v>
                </c:pt>
                <c:pt idx="2">
                  <c:v>1949</c:v>
                </c:pt>
                <c:pt idx="3">
                  <c:v>1950</c:v>
                </c:pt>
                <c:pt idx="4">
                  <c:v>1951</c:v>
                </c:pt>
                <c:pt idx="5">
                  <c:v>1952</c:v>
                </c:pt>
                <c:pt idx="6">
                  <c:v>1953</c:v>
                </c:pt>
                <c:pt idx="7">
                  <c:v>1954</c:v>
                </c:pt>
                <c:pt idx="8">
                  <c:v>1955</c:v>
                </c:pt>
                <c:pt idx="9">
                  <c:v>1956</c:v>
                </c:pt>
                <c:pt idx="10">
                  <c:v>1957</c:v>
                </c:pt>
                <c:pt idx="11">
                  <c:v>1958</c:v>
                </c:pt>
                <c:pt idx="12">
                  <c:v>1959</c:v>
                </c:pt>
                <c:pt idx="13">
                  <c:v>1960</c:v>
                </c:pt>
                <c:pt idx="14">
                  <c:v>1961</c:v>
                </c:pt>
                <c:pt idx="15">
                  <c:v>1962</c:v>
                </c:pt>
                <c:pt idx="16">
                  <c:v>1963</c:v>
                </c:pt>
                <c:pt idx="17">
                  <c:v>1964</c:v>
                </c:pt>
                <c:pt idx="18">
                  <c:v>1965</c:v>
                </c:pt>
                <c:pt idx="19">
                  <c:v>1966</c:v>
                </c:pt>
                <c:pt idx="20">
                  <c:v>1967</c:v>
                </c:pt>
                <c:pt idx="21">
                  <c:v>1968</c:v>
                </c:pt>
                <c:pt idx="22">
                  <c:v>1969</c:v>
                </c:pt>
                <c:pt idx="23">
                  <c:v>1970</c:v>
                </c:pt>
                <c:pt idx="24">
                  <c:v>1971</c:v>
                </c:pt>
                <c:pt idx="25">
                  <c:v>1972</c:v>
                </c:pt>
                <c:pt idx="26">
                  <c:v>1973</c:v>
                </c:pt>
                <c:pt idx="27">
                  <c:v>1974</c:v>
                </c:pt>
                <c:pt idx="28">
                  <c:v>1975</c:v>
                </c:pt>
                <c:pt idx="29">
                  <c:v>1976</c:v>
                </c:pt>
                <c:pt idx="30">
                  <c:v>1977</c:v>
                </c:pt>
                <c:pt idx="31">
                  <c:v>1978</c:v>
                </c:pt>
                <c:pt idx="32">
                  <c:v>1979</c:v>
                </c:pt>
                <c:pt idx="33">
                  <c:v>1980</c:v>
                </c:pt>
                <c:pt idx="34">
                  <c:v>1981</c:v>
                </c:pt>
                <c:pt idx="35">
                  <c:v>1982</c:v>
                </c:pt>
                <c:pt idx="36">
                  <c:v>1983</c:v>
                </c:pt>
                <c:pt idx="37">
                  <c:v>1984</c:v>
                </c:pt>
                <c:pt idx="38">
                  <c:v>1985</c:v>
                </c:pt>
                <c:pt idx="39">
                  <c:v>1986</c:v>
                </c:pt>
                <c:pt idx="40">
                  <c:v>1987</c:v>
                </c:pt>
                <c:pt idx="41">
                  <c:v>1988</c:v>
                </c:pt>
                <c:pt idx="42">
                  <c:v>1989</c:v>
                </c:pt>
                <c:pt idx="43">
                  <c:v>1990</c:v>
                </c:pt>
                <c:pt idx="44">
                  <c:v>1991</c:v>
                </c:pt>
                <c:pt idx="45">
                  <c:v>1992</c:v>
                </c:pt>
                <c:pt idx="46">
                  <c:v>1993</c:v>
                </c:pt>
                <c:pt idx="47">
                  <c:v>1994</c:v>
                </c:pt>
                <c:pt idx="48">
                  <c:v>1995</c:v>
                </c:pt>
                <c:pt idx="49">
                  <c:v>1996</c:v>
                </c:pt>
                <c:pt idx="50">
                  <c:v>1997</c:v>
                </c:pt>
                <c:pt idx="51">
                  <c:v>1998</c:v>
                </c:pt>
                <c:pt idx="52">
                  <c:v>1999</c:v>
                </c:pt>
                <c:pt idx="53">
                  <c:v>2000</c:v>
                </c:pt>
                <c:pt idx="54">
                  <c:v>2001</c:v>
                </c:pt>
                <c:pt idx="55">
                  <c:v>2002</c:v>
                </c:pt>
                <c:pt idx="56">
                  <c:v>2003</c:v>
                </c:pt>
                <c:pt idx="57">
                  <c:v>2004</c:v>
                </c:pt>
                <c:pt idx="58">
                  <c:v>2005</c:v>
                </c:pt>
                <c:pt idx="59">
                  <c:v>2006</c:v>
                </c:pt>
                <c:pt idx="60">
                  <c:v>2007</c:v>
                </c:pt>
                <c:pt idx="61">
                  <c:v>2008</c:v>
                </c:pt>
                <c:pt idx="62">
                  <c:v>2009</c:v>
                </c:pt>
                <c:pt idx="63">
                  <c:v>2010</c:v>
                </c:pt>
                <c:pt idx="64">
                  <c:v>2011</c:v>
                </c:pt>
                <c:pt idx="65">
                  <c:v>2012</c:v>
                </c:pt>
                <c:pt idx="66">
                  <c:v>2013</c:v>
                </c:pt>
                <c:pt idx="67">
                  <c:v>2014</c:v>
                </c:pt>
                <c:pt idx="68">
                  <c:v>2015</c:v>
                </c:pt>
                <c:pt idx="69">
                  <c:v>2016</c:v>
                </c:pt>
                <c:pt idx="70">
                  <c:v>2017</c:v>
                </c:pt>
              </c:strCache>
            </c:strRef>
          </c:cat>
          <c:val>
            <c:numRef>
              <c:f>Sheet1!$F$2:$F$72</c:f>
              <c:numCache>
                <c:formatCode>0.0_);[Red]\(0.0\)</c:formatCode>
                <c:ptCount val="71"/>
                <c:pt idx="0">
                  <c:v>20.936452970836832</c:v>
                </c:pt>
                <c:pt idx="1">
                  <c:v>21.068121633179036</c:v>
                </c:pt>
                <c:pt idx="2">
                  <c:v>20.967318126149586</c:v>
                </c:pt>
                <c:pt idx="3">
                  <c:v>21.011843374764698</c:v>
                </c:pt>
                <c:pt idx="4">
                  <c:v>21.197042143889689</c:v>
                </c:pt>
                <c:pt idx="5">
                  <c:v>20.910871854579703</c:v>
                </c:pt>
                <c:pt idx="6">
                  <c:v>21.142306758702212</c:v>
                </c:pt>
                <c:pt idx="7">
                  <c:v>20.847410915697825</c:v>
                </c:pt>
                <c:pt idx="8">
                  <c:v>20.999038465080805</c:v>
                </c:pt>
                <c:pt idx="9">
                  <c:v>21.008369094862246</c:v>
                </c:pt>
                <c:pt idx="10">
                  <c:v>21.195943818923517</c:v>
                </c:pt>
                <c:pt idx="11">
                  <c:v>21.253078588863826</c:v>
                </c:pt>
                <c:pt idx="12">
                  <c:v>21.188084464738854</c:v>
                </c:pt>
                <c:pt idx="13">
                  <c:v>21.392002927585239</c:v>
                </c:pt>
                <c:pt idx="14">
                  <c:v>21.228690376758674</c:v>
                </c:pt>
                <c:pt idx="15">
                  <c:v>21.439936695723102</c:v>
                </c:pt>
                <c:pt idx="16">
                  <c:v>21.573525590170103</c:v>
                </c:pt>
                <c:pt idx="17">
                  <c:v>21.344864206064646</c:v>
                </c:pt>
                <c:pt idx="18">
                  <c:v>21.415971264157523</c:v>
                </c:pt>
                <c:pt idx="19">
                  <c:v>21.482489292013103</c:v>
                </c:pt>
                <c:pt idx="20">
                  <c:v>21.466035573777265</c:v>
                </c:pt>
                <c:pt idx="21">
                  <c:v>21.660398829435451</c:v>
                </c:pt>
                <c:pt idx="22">
                  <c:v>21.620442365998009</c:v>
                </c:pt>
                <c:pt idx="23">
                  <c:v>21.722729571669966</c:v>
                </c:pt>
                <c:pt idx="24">
                  <c:v>22.191569637713499</c:v>
                </c:pt>
                <c:pt idx="25">
                  <c:v>22.219866185222688</c:v>
                </c:pt>
                <c:pt idx="26">
                  <c:v>21.641605448423626</c:v>
                </c:pt>
                <c:pt idx="28">
                  <c:v>21.963856853263433</c:v>
                </c:pt>
                <c:pt idx="29">
                  <c:v>22.119872972145696</c:v>
                </c:pt>
                <c:pt idx="30">
                  <c:v>22.225295933361942</c:v>
                </c:pt>
                <c:pt idx="31">
                  <c:v>22.008578190331765</c:v>
                </c:pt>
                <c:pt idx="32">
                  <c:v>22.139306536719367</c:v>
                </c:pt>
                <c:pt idx="33">
                  <c:v>22.071911712353149</c:v>
                </c:pt>
                <c:pt idx="34">
                  <c:v>22.630346862213855</c:v>
                </c:pt>
                <c:pt idx="35">
                  <c:v>22.523363567575004</c:v>
                </c:pt>
                <c:pt idx="36">
                  <c:v>22.4609375</c:v>
                </c:pt>
                <c:pt idx="37">
                  <c:v>22.415861712813115</c:v>
                </c:pt>
                <c:pt idx="38">
                  <c:v>22.560750372895306</c:v>
                </c:pt>
                <c:pt idx="39">
                  <c:v>22.515309439931677</c:v>
                </c:pt>
                <c:pt idx="40">
                  <c:v>22.621127978059839</c:v>
                </c:pt>
                <c:pt idx="41">
                  <c:v>22.753749468150318</c:v>
                </c:pt>
                <c:pt idx="42">
                  <c:v>22.907491018610795</c:v>
                </c:pt>
                <c:pt idx="43">
                  <c:v>22.645731260368045</c:v>
                </c:pt>
                <c:pt idx="44">
                  <c:v>22.343132429720786</c:v>
                </c:pt>
                <c:pt idx="45">
                  <c:v>22.676878692920081</c:v>
                </c:pt>
                <c:pt idx="46">
                  <c:v>22.965810081568883</c:v>
                </c:pt>
                <c:pt idx="47">
                  <c:v>22.882042689833533</c:v>
                </c:pt>
                <c:pt idx="48">
                  <c:v>23.176538731916629</c:v>
                </c:pt>
                <c:pt idx="49">
                  <c:v>23.053216530369578</c:v>
                </c:pt>
                <c:pt idx="50">
                  <c:v>23.214201183431953</c:v>
                </c:pt>
                <c:pt idx="51">
                  <c:v>23.499228777330192</c:v>
                </c:pt>
                <c:pt idx="52">
                  <c:v>23.157163855633787</c:v>
                </c:pt>
                <c:pt idx="53">
                  <c:v>23.523655387858032</c:v>
                </c:pt>
                <c:pt idx="54">
                  <c:v>23.645185385395848</c:v>
                </c:pt>
                <c:pt idx="55">
                  <c:v>23.645185385395848</c:v>
                </c:pt>
                <c:pt idx="56">
                  <c:v>23.679263810565889</c:v>
                </c:pt>
                <c:pt idx="57">
                  <c:v>23.811607899222754</c:v>
                </c:pt>
                <c:pt idx="58">
                  <c:v>23.737428435362244</c:v>
                </c:pt>
                <c:pt idx="59">
                  <c:v>23.869720404521118</c:v>
                </c:pt>
                <c:pt idx="60">
                  <c:v>23.78</c:v>
                </c:pt>
                <c:pt idx="61">
                  <c:v>23.63</c:v>
                </c:pt>
                <c:pt idx="62">
                  <c:v>23.6</c:v>
                </c:pt>
                <c:pt idx="63">
                  <c:v>23.63</c:v>
                </c:pt>
                <c:pt idx="64">
                  <c:v>23.74</c:v>
                </c:pt>
                <c:pt idx="65">
                  <c:v>23.6</c:v>
                </c:pt>
                <c:pt idx="66" formatCode="General">
                  <c:v>23.58</c:v>
                </c:pt>
                <c:pt idx="67" formatCode="General">
                  <c:v>23.62</c:v>
                </c:pt>
                <c:pt idx="68" formatCode="General">
                  <c:v>23.74</c:v>
                </c:pt>
                <c:pt idx="69" formatCode="General">
                  <c:v>23.9</c:v>
                </c:pt>
                <c:pt idx="70" formatCode="General">
                  <c:v>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2063-48D8-983C-369F4DB5CB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03507904"/>
        <c:axId val="303513344"/>
      </c:lineChart>
      <c:catAx>
        <c:axId val="303507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03513344"/>
        <c:crosses val="autoZero"/>
        <c:auto val="1"/>
        <c:lblAlgn val="ctr"/>
        <c:lblOffset val="100"/>
        <c:noMultiLvlLbl val="0"/>
      </c:catAx>
      <c:valAx>
        <c:axId val="303513344"/>
        <c:scaling>
          <c:orientation val="minMax"/>
          <c:min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_);[Red]\(0.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035079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dirty="0"/>
              <a:t>Women</a:t>
            </a:r>
            <a:endParaRPr lang="ja-JP" altLang="en-US" dirty="0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5851805080968656"/>
          <c:y val="0.11238301053705907"/>
          <c:w val="0.82889342841578773"/>
          <c:h val="0.67905658246388512"/>
        </c:manualLayout>
      </c:layout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20－29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Sheet1!$A$2:$A$72</c:f>
              <c:strCache>
                <c:ptCount val="71"/>
                <c:pt idx="0">
                  <c:v>1947</c:v>
                </c:pt>
                <c:pt idx="1">
                  <c:v>1948</c:v>
                </c:pt>
                <c:pt idx="2">
                  <c:v>1949</c:v>
                </c:pt>
                <c:pt idx="3">
                  <c:v>1950</c:v>
                </c:pt>
                <c:pt idx="4">
                  <c:v>1951</c:v>
                </c:pt>
                <c:pt idx="5">
                  <c:v>1952</c:v>
                </c:pt>
                <c:pt idx="6">
                  <c:v>1953</c:v>
                </c:pt>
                <c:pt idx="7">
                  <c:v>1954</c:v>
                </c:pt>
                <c:pt idx="8">
                  <c:v>1955</c:v>
                </c:pt>
                <c:pt idx="9">
                  <c:v>1956</c:v>
                </c:pt>
                <c:pt idx="10">
                  <c:v>1957</c:v>
                </c:pt>
                <c:pt idx="11">
                  <c:v>1958</c:v>
                </c:pt>
                <c:pt idx="12">
                  <c:v>1959</c:v>
                </c:pt>
                <c:pt idx="13">
                  <c:v>1960</c:v>
                </c:pt>
                <c:pt idx="14">
                  <c:v>1961</c:v>
                </c:pt>
                <c:pt idx="15">
                  <c:v>1962</c:v>
                </c:pt>
                <c:pt idx="16">
                  <c:v>1963</c:v>
                </c:pt>
                <c:pt idx="17">
                  <c:v>1964</c:v>
                </c:pt>
                <c:pt idx="18">
                  <c:v>1965</c:v>
                </c:pt>
                <c:pt idx="19">
                  <c:v>1966</c:v>
                </c:pt>
                <c:pt idx="20">
                  <c:v>1967</c:v>
                </c:pt>
                <c:pt idx="21">
                  <c:v>1968</c:v>
                </c:pt>
                <c:pt idx="22">
                  <c:v>1969</c:v>
                </c:pt>
                <c:pt idx="23">
                  <c:v>1970</c:v>
                </c:pt>
                <c:pt idx="24">
                  <c:v>1971</c:v>
                </c:pt>
                <c:pt idx="25">
                  <c:v>1972</c:v>
                </c:pt>
                <c:pt idx="26">
                  <c:v>1973</c:v>
                </c:pt>
                <c:pt idx="27">
                  <c:v>1974</c:v>
                </c:pt>
                <c:pt idx="28">
                  <c:v>1975</c:v>
                </c:pt>
                <c:pt idx="29">
                  <c:v>1976</c:v>
                </c:pt>
                <c:pt idx="30">
                  <c:v>1977</c:v>
                </c:pt>
                <c:pt idx="31">
                  <c:v>1978</c:v>
                </c:pt>
                <c:pt idx="32">
                  <c:v>1979</c:v>
                </c:pt>
                <c:pt idx="33">
                  <c:v>1980</c:v>
                </c:pt>
                <c:pt idx="34">
                  <c:v>1981</c:v>
                </c:pt>
                <c:pt idx="35">
                  <c:v>1982</c:v>
                </c:pt>
                <c:pt idx="36">
                  <c:v>1983</c:v>
                </c:pt>
                <c:pt idx="37">
                  <c:v>1984</c:v>
                </c:pt>
                <c:pt idx="38">
                  <c:v>1985</c:v>
                </c:pt>
                <c:pt idx="39">
                  <c:v>1986</c:v>
                </c:pt>
                <c:pt idx="40">
                  <c:v>1987</c:v>
                </c:pt>
                <c:pt idx="41">
                  <c:v>1988</c:v>
                </c:pt>
                <c:pt idx="42">
                  <c:v>1989</c:v>
                </c:pt>
                <c:pt idx="43">
                  <c:v>1990</c:v>
                </c:pt>
                <c:pt idx="44">
                  <c:v>1991</c:v>
                </c:pt>
                <c:pt idx="45">
                  <c:v>1992</c:v>
                </c:pt>
                <c:pt idx="46">
                  <c:v>1993</c:v>
                </c:pt>
                <c:pt idx="47">
                  <c:v>1994</c:v>
                </c:pt>
                <c:pt idx="48">
                  <c:v>1995</c:v>
                </c:pt>
                <c:pt idx="49">
                  <c:v>1996</c:v>
                </c:pt>
                <c:pt idx="50">
                  <c:v>1997</c:v>
                </c:pt>
                <c:pt idx="51">
                  <c:v>1998</c:v>
                </c:pt>
                <c:pt idx="52">
                  <c:v>1999</c:v>
                </c:pt>
                <c:pt idx="53">
                  <c:v>2000</c:v>
                </c:pt>
                <c:pt idx="54">
                  <c:v>2001</c:v>
                </c:pt>
                <c:pt idx="55">
                  <c:v>2002</c:v>
                </c:pt>
                <c:pt idx="56">
                  <c:v>2003</c:v>
                </c:pt>
                <c:pt idx="57">
                  <c:v>2004</c:v>
                </c:pt>
                <c:pt idx="58">
                  <c:v>2005</c:v>
                </c:pt>
                <c:pt idx="59">
                  <c:v>2006</c:v>
                </c:pt>
                <c:pt idx="60">
                  <c:v>2007</c:v>
                </c:pt>
                <c:pt idx="61">
                  <c:v>2008</c:v>
                </c:pt>
                <c:pt idx="62">
                  <c:v>2009</c:v>
                </c:pt>
                <c:pt idx="63">
                  <c:v>2010</c:v>
                </c:pt>
                <c:pt idx="64">
                  <c:v>2011</c:v>
                </c:pt>
                <c:pt idx="65">
                  <c:v>2012</c:v>
                </c:pt>
                <c:pt idx="66">
                  <c:v>2013</c:v>
                </c:pt>
                <c:pt idx="67">
                  <c:v>2014</c:v>
                </c:pt>
                <c:pt idx="68">
                  <c:v>2015</c:v>
                </c:pt>
                <c:pt idx="69">
                  <c:v>2016</c:v>
                </c:pt>
                <c:pt idx="70">
                  <c:v>2017</c:v>
                </c:pt>
              </c:strCache>
            </c:strRef>
          </c:cat>
          <c:val>
            <c:numRef>
              <c:f>Sheet1!$B$2:$B$72</c:f>
              <c:numCache>
                <c:formatCode>0.0_);[Red]\(0.0\)</c:formatCode>
                <c:ptCount val="71"/>
                <c:pt idx="0">
                  <c:v>22.293360897068837</c:v>
                </c:pt>
                <c:pt idx="1">
                  <c:v>22.154282324942997</c:v>
                </c:pt>
                <c:pt idx="2">
                  <c:v>22.248492931780103</c:v>
                </c:pt>
                <c:pt idx="3">
                  <c:v>21.994084380425956</c:v>
                </c:pt>
                <c:pt idx="4">
                  <c:v>21.974071163100344</c:v>
                </c:pt>
                <c:pt idx="5">
                  <c:v>21.592874151644647</c:v>
                </c:pt>
                <c:pt idx="6">
                  <c:v>21.667923182151199</c:v>
                </c:pt>
                <c:pt idx="7">
                  <c:v>21.630440732899196</c:v>
                </c:pt>
                <c:pt idx="8">
                  <c:v>21.50235781943914</c:v>
                </c:pt>
                <c:pt idx="9">
                  <c:v>21.535194559211881</c:v>
                </c:pt>
                <c:pt idx="10">
                  <c:v>21.587719423990446</c:v>
                </c:pt>
                <c:pt idx="11">
                  <c:v>21.722166232748243</c:v>
                </c:pt>
                <c:pt idx="12">
                  <c:v>21.507556739852255</c:v>
                </c:pt>
                <c:pt idx="13">
                  <c:v>21.624802483164839</c:v>
                </c:pt>
                <c:pt idx="14">
                  <c:v>21.491724692732959</c:v>
                </c:pt>
                <c:pt idx="15">
                  <c:v>21.297427193193098</c:v>
                </c:pt>
                <c:pt idx="16">
                  <c:v>21.254314992397163</c:v>
                </c:pt>
                <c:pt idx="17">
                  <c:v>21.201104684630355</c:v>
                </c:pt>
                <c:pt idx="18">
                  <c:v>21.288750111456636</c:v>
                </c:pt>
                <c:pt idx="19">
                  <c:v>21.145713187235678</c:v>
                </c:pt>
                <c:pt idx="20">
                  <c:v>21.260967080012819</c:v>
                </c:pt>
                <c:pt idx="21">
                  <c:v>21.233238400758438</c:v>
                </c:pt>
                <c:pt idx="22">
                  <c:v>21.333052292325711</c:v>
                </c:pt>
                <c:pt idx="23">
                  <c:v>21.306782151680615</c:v>
                </c:pt>
                <c:pt idx="24">
                  <c:v>21.50303677274265</c:v>
                </c:pt>
                <c:pt idx="25">
                  <c:v>21.279486820221567</c:v>
                </c:pt>
                <c:pt idx="26">
                  <c:v>21.133145634642002</c:v>
                </c:pt>
                <c:pt idx="28">
                  <c:v>20.847875110741228</c:v>
                </c:pt>
                <c:pt idx="29">
                  <c:v>20.857440166493234</c:v>
                </c:pt>
                <c:pt idx="30">
                  <c:v>20.919776802634484</c:v>
                </c:pt>
                <c:pt idx="31">
                  <c:v>21.025567089580935</c:v>
                </c:pt>
                <c:pt idx="32">
                  <c:v>20.659702435308496</c:v>
                </c:pt>
                <c:pt idx="33">
                  <c:v>21.270341059345903</c:v>
                </c:pt>
                <c:pt idx="34">
                  <c:v>20.877289503722093</c:v>
                </c:pt>
                <c:pt idx="35">
                  <c:v>20.899381332204989</c:v>
                </c:pt>
                <c:pt idx="36">
                  <c:v>20.589545917469103</c:v>
                </c:pt>
                <c:pt idx="37">
                  <c:v>20.858578166777015</c:v>
                </c:pt>
                <c:pt idx="38">
                  <c:v>20.554391754520445</c:v>
                </c:pt>
                <c:pt idx="39">
                  <c:v>20.409573666234358</c:v>
                </c:pt>
                <c:pt idx="40">
                  <c:v>20.476573098067234</c:v>
                </c:pt>
                <c:pt idx="41">
                  <c:v>20.299254203711296</c:v>
                </c:pt>
                <c:pt idx="42">
                  <c:v>20.799746194536713</c:v>
                </c:pt>
                <c:pt idx="43">
                  <c:v>20.827648784488726</c:v>
                </c:pt>
                <c:pt idx="44">
                  <c:v>20.407288913644905</c:v>
                </c:pt>
                <c:pt idx="45">
                  <c:v>20.101380835254957</c:v>
                </c:pt>
                <c:pt idx="46">
                  <c:v>20.561555353152745</c:v>
                </c:pt>
                <c:pt idx="47">
                  <c:v>20.555472231012626</c:v>
                </c:pt>
                <c:pt idx="48">
                  <c:v>20.349302996314691</c:v>
                </c:pt>
                <c:pt idx="49">
                  <c:v>20.499422237962552</c:v>
                </c:pt>
                <c:pt idx="50">
                  <c:v>20.417752816531113</c:v>
                </c:pt>
                <c:pt idx="51">
                  <c:v>20.548746698159018</c:v>
                </c:pt>
                <c:pt idx="52">
                  <c:v>20.575628268586946</c:v>
                </c:pt>
                <c:pt idx="53">
                  <c:v>20.49541139424548</c:v>
                </c:pt>
                <c:pt idx="54">
                  <c:v>20.492991316447217</c:v>
                </c:pt>
                <c:pt idx="55">
                  <c:v>20.380340136731384</c:v>
                </c:pt>
                <c:pt idx="56">
                  <c:v>20.697448060593178</c:v>
                </c:pt>
                <c:pt idx="57">
                  <c:v>20.31215269311609</c:v>
                </c:pt>
                <c:pt idx="58">
                  <c:v>20.422374356794347</c:v>
                </c:pt>
                <c:pt idx="59">
                  <c:v>20.683632045787242</c:v>
                </c:pt>
                <c:pt idx="60">
                  <c:v>20.28</c:v>
                </c:pt>
                <c:pt idx="61">
                  <c:v>20.71</c:v>
                </c:pt>
                <c:pt idx="62">
                  <c:v>20.420000000000002</c:v>
                </c:pt>
                <c:pt idx="63">
                  <c:v>20.37</c:v>
                </c:pt>
                <c:pt idx="64">
                  <c:v>20.8</c:v>
                </c:pt>
                <c:pt idx="65">
                  <c:v>20.8</c:v>
                </c:pt>
                <c:pt idx="66" formatCode="General">
                  <c:v>20.93</c:v>
                </c:pt>
                <c:pt idx="67" formatCode="General">
                  <c:v>21.09</c:v>
                </c:pt>
                <c:pt idx="68" formatCode="General">
                  <c:v>20.82</c:v>
                </c:pt>
                <c:pt idx="69" formatCode="General">
                  <c:v>20.9</c:v>
                </c:pt>
                <c:pt idx="70" formatCode="General">
                  <c:v>20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9F9-46A2-BB1F-D17F7325D8C3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30－39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Sheet1!$A$2:$A$72</c:f>
              <c:strCache>
                <c:ptCount val="71"/>
                <c:pt idx="0">
                  <c:v>1947</c:v>
                </c:pt>
                <c:pt idx="1">
                  <c:v>1948</c:v>
                </c:pt>
                <c:pt idx="2">
                  <c:v>1949</c:v>
                </c:pt>
                <c:pt idx="3">
                  <c:v>1950</c:v>
                </c:pt>
                <c:pt idx="4">
                  <c:v>1951</c:v>
                </c:pt>
                <c:pt idx="5">
                  <c:v>1952</c:v>
                </c:pt>
                <c:pt idx="6">
                  <c:v>1953</c:v>
                </c:pt>
                <c:pt idx="7">
                  <c:v>1954</c:v>
                </c:pt>
                <c:pt idx="8">
                  <c:v>1955</c:v>
                </c:pt>
                <c:pt idx="9">
                  <c:v>1956</c:v>
                </c:pt>
                <c:pt idx="10">
                  <c:v>1957</c:v>
                </c:pt>
                <c:pt idx="11">
                  <c:v>1958</c:v>
                </c:pt>
                <c:pt idx="12">
                  <c:v>1959</c:v>
                </c:pt>
                <c:pt idx="13">
                  <c:v>1960</c:v>
                </c:pt>
                <c:pt idx="14">
                  <c:v>1961</c:v>
                </c:pt>
                <c:pt idx="15">
                  <c:v>1962</c:v>
                </c:pt>
                <c:pt idx="16">
                  <c:v>1963</c:v>
                </c:pt>
                <c:pt idx="17">
                  <c:v>1964</c:v>
                </c:pt>
                <c:pt idx="18">
                  <c:v>1965</c:v>
                </c:pt>
                <c:pt idx="19">
                  <c:v>1966</c:v>
                </c:pt>
                <c:pt idx="20">
                  <c:v>1967</c:v>
                </c:pt>
                <c:pt idx="21">
                  <c:v>1968</c:v>
                </c:pt>
                <c:pt idx="22">
                  <c:v>1969</c:v>
                </c:pt>
                <c:pt idx="23">
                  <c:v>1970</c:v>
                </c:pt>
                <c:pt idx="24">
                  <c:v>1971</c:v>
                </c:pt>
                <c:pt idx="25">
                  <c:v>1972</c:v>
                </c:pt>
                <c:pt idx="26">
                  <c:v>1973</c:v>
                </c:pt>
                <c:pt idx="27">
                  <c:v>1974</c:v>
                </c:pt>
                <c:pt idx="28">
                  <c:v>1975</c:v>
                </c:pt>
                <c:pt idx="29">
                  <c:v>1976</c:v>
                </c:pt>
                <c:pt idx="30">
                  <c:v>1977</c:v>
                </c:pt>
                <c:pt idx="31">
                  <c:v>1978</c:v>
                </c:pt>
                <c:pt idx="32">
                  <c:v>1979</c:v>
                </c:pt>
                <c:pt idx="33">
                  <c:v>1980</c:v>
                </c:pt>
                <c:pt idx="34">
                  <c:v>1981</c:v>
                </c:pt>
                <c:pt idx="35">
                  <c:v>1982</c:v>
                </c:pt>
                <c:pt idx="36">
                  <c:v>1983</c:v>
                </c:pt>
                <c:pt idx="37">
                  <c:v>1984</c:v>
                </c:pt>
                <c:pt idx="38">
                  <c:v>1985</c:v>
                </c:pt>
                <c:pt idx="39">
                  <c:v>1986</c:v>
                </c:pt>
                <c:pt idx="40">
                  <c:v>1987</c:v>
                </c:pt>
                <c:pt idx="41">
                  <c:v>1988</c:v>
                </c:pt>
                <c:pt idx="42">
                  <c:v>1989</c:v>
                </c:pt>
                <c:pt idx="43">
                  <c:v>1990</c:v>
                </c:pt>
                <c:pt idx="44">
                  <c:v>1991</c:v>
                </c:pt>
                <c:pt idx="45">
                  <c:v>1992</c:v>
                </c:pt>
                <c:pt idx="46">
                  <c:v>1993</c:v>
                </c:pt>
                <c:pt idx="47">
                  <c:v>1994</c:v>
                </c:pt>
                <c:pt idx="48">
                  <c:v>1995</c:v>
                </c:pt>
                <c:pt idx="49">
                  <c:v>1996</c:v>
                </c:pt>
                <c:pt idx="50">
                  <c:v>1997</c:v>
                </c:pt>
                <c:pt idx="51">
                  <c:v>1998</c:v>
                </c:pt>
                <c:pt idx="52">
                  <c:v>1999</c:v>
                </c:pt>
                <c:pt idx="53">
                  <c:v>2000</c:v>
                </c:pt>
                <c:pt idx="54">
                  <c:v>2001</c:v>
                </c:pt>
                <c:pt idx="55">
                  <c:v>2002</c:v>
                </c:pt>
                <c:pt idx="56">
                  <c:v>2003</c:v>
                </c:pt>
                <c:pt idx="57">
                  <c:v>2004</c:v>
                </c:pt>
                <c:pt idx="58">
                  <c:v>2005</c:v>
                </c:pt>
                <c:pt idx="59">
                  <c:v>2006</c:v>
                </c:pt>
                <c:pt idx="60">
                  <c:v>2007</c:v>
                </c:pt>
                <c:pt idx="61">
                  <c:v>2008</c:v>
                </c:pt>
                <c:pt idx="62">
                  <c:v>2009</c:v>
                </c:pt>
                <c:pt idx="63">
                  <c:v>2010</c:v>
                </c:pt>
                <c:pt idx="64">
                  <c:v>2011</c:v>
                </c:pt>
                <c:pt idx="65">
                  <c:v>2012</c:v>
                </c:pt>
                <c:pt idx="66">
                  <c:v>2013</c:v>
                </c:pt>
                <c:pt idx="67">
                  <c:v>2014</c:v>
                </c:pt>
                <c:pt idx="68">
                  <c:v>2015</c:v>
                </c:pt>
                <c:pt idx="69">
                  <c:v>2016</c:v>
                </c:pt>
                <c:pt idx="70">
                  <c:v>2017</c:v>
                </c:pt>
              </c:strCache>
            </c:strRef>
          </c:cat>
          <c:val>
            <c:numRef>
              <c:f>Sheet1!$C$2:$C$72</c:f>
              <c:numCache>
                <c:formatCode>0.0_);[Red]\(0.0\)</c:formatCode>
                <c:ptCount val="71"/>
                <c:pt idx="0">
                  <c:v>22.209971286681387</c:v>
                </c:pt>
                <c:pt idx="1">
                  <c:v>21.900111284541566</c:v>
                </c:pt>
                <c:pt idx="2">
                  <c:v>22.430074141969286</c:v>
                </c:pt>
                <c:pt idx="3">
                  <c:v>22.190940413265672</c:v>
                </c:pt>
                <c:pt idx="4">
                  <c:v>22.114264399642597</c:v>
                </c:pt>
                <c:pt idx="5">
                  <c:v>21.81631077952148</c:v>
                </c:pt>
                <c:pt idx="6">
                  <c:v>21.877178733405692</c:v>
                </c:pt>
                <c:pt idx="7">
                  <c:v>21.641516180218559</c:v>
                </c:pt>
                <c:pt idx="8">
                  <c:v>21.708809451923216</c:v>
                </c:pt>
                <c:pt idx="9">
                  <c:v>21.731282649913503</c:v>
                </c:pt>
                <c:pt idx="10">
                  <c:v>21.820528163876183</c:v>
                </c:pt>
                <c:pt idx="11">
                  <c:v>21.733333333333334</c:v>
                </c:pt>
                <c:pt idx="12">
                  <c:v>21.742222222222225</c:v>
                </c:pt>
                <c:pt idx="13">
                  <c:v>21.885702978606986</c:v>
                </c:pt>
                <c:pt idx="14">
                  <c:v>21.850289219741928</c:v>
                </c:pt>
                <c:pt idx="15">
                  <c:v>21.826188879534804</c:v>
                </c:pt>
                <c:pt idx="16">
                  <c:v>22.001852371523015</c:v>
                </c:pt>
                <c:pt idx="17">
                  <c:v>21.912986652919404</c:v>
                </c:pt>
                <c:pt idx="18">
                  <c:v>22.075045518831459</c:v>
                </c:pt>
                <c:pt idx="19">
                  <c:v>21.936847150061542</c:v>
                </c:pt>
                <c:pt idx="20">
                  <c:v>22.172118201919201</c:v>
                </c:pt>
                <c:pt idx="21">
                  <c:v>22.220043786556875</c:v>
                </c:pt>
                <c:pt idx="22">
                  <c:v>22.24840078755863</c:v>
                </c:pt>
                <c:pt idx="23">
                  <c:v>22.302535233975092</c:v>
                </c:pt>
                <c:pt idx="24">
                  <c:v>22.642042827053185</c:v>
                </c:pt>
                <c:pt idx="25">
                  <c:v>22.304437415953121</c:v>
                </c:pt>
                <c:pt idx="26">
                  <c:v>22.377077562326875</c:v>
                </c:pt>
                <c:pt idx="28">
                  <c:v>22.129501327126786</c:v>
                </c:pt>
                <c:pt idx="29">
                  <c:v>22.186206518461663</c:v>
                </c:pt>
                <c:pt idx="30">
                  <c:v>21.871512100180034</c:v>
                </c:pt>
                <c:pt idx="31">
                  <c:v>22.170959887222864</c:v>
                </c:pt>
                <c:pt idx="32">
                  <c:v>21.970494093889229</c:v>
                </c:pt>
                <c:pt idx="33">
                  <c:v>22.055486334097694</c:v>
                </c:pt>
                <c:pt idx="34">
                  <c:v>22.254476319832992</c:v>
                </c:pt>
                <c:pt idx="35">
                  <c:v>22.024010803977461</c:v>
                </c:pt>
                <c:pt idx="36">
                  <c:v>21.995454553101155</c:v>
                </c:pt>
                <c:pt idx="37">
                  <c:v>21.812666111841924</c:v>
                </c:pt>
                <c:pt idx="38">
                  <c:v>21.923622117085532</c:v>
                </c:pt>
                <c:pt idx="39">
                  <c:v>21.852237252861602</c:v>
                </c:pt>
                <c:pt idx="40">
                  <c:v>21.907207388091376</c:v>
                </c:pt>
                <c:pt idx="41">
                  <c:v>21.712921139334682</c:v>
                </c:pt>
                <c:pt idx="42">
                  <c:v>21.614941369471538</c:v>
                </c:pt>
                <c:pt idx="43">
                  <c:v>21.738691033800578</c:v>
                </c:pt>
                <c:pt idx="44">
                  <c:v>21.791579750000107</c:v>
                </c:pt>
                <c:pt idx="45">
                  <c:v>21.735846832276625</c:v>
                </c:pt>
                <c:pt idx="46">
                  <c:v>21.639498208617013</c:v>
                </c:pt>
                <c:pt idx="47">
                  <c:v>21.665745600978056</c:v>
                </c:pt>
                <c:pt idx="48">
                  <c:v>21.530316153119696</c:v>
                </c:pt>
                <c:pt idx="49">
                  <c:v>21.4745216955472</c:v>
                </c:pt>
                <c:pt idx="50">
                  <c:v>21.62359527769889</c:v>
                </c:pt>
                <c:pt idx="51">
                  <c:v>21.568608407953434</c:v>
                </c:pt>
                <c:pt idx="52">
                  <c:v>21.539784586049631</c:v>
                </c:pt>
                <c:pt idx="53">
                  <c:v>21.459262026849441</c:v>
                </c:pt>
                <c:pt idx="54">
                  <c:v>21.486520534139583</c:v>
                </c:pt>
                <c:pt idx="55">
                  <c:v>21.177254826147969</c:v>
                </c:pt>
                <c:pt idx="56">
                  <c:v>21.472265593428684</c:v>
                </c:pt>
                <c:pt idx="57">
                  <c:v>20.950168242268866</c:v>
                </c:pt>
                <c:pt idx="58">
                  <c:v>21.349708626359746</c:v>
                </c:pt>
                <c:pt idx="59">
                  <c:v>21.507547916908514</c:v>
                </c:pt>
                <c:pt idx="60">
                  <c:v>21.24</c:v>
                </c:pt>
                <c:pt idx="61">
                  <c:v>21.29</c:v>
                </c:pt>
                <c:pt idx="62">
                  <c:v>21.6</c:v>
                </c:pt>
                <c:pt idx="63">
                  <c:v>21.56</c:v>
                </c:pt>
                <c:pt idx="64">
                  <c:v>21.54</c:v>
                </c:pt>
                <c:pt idx="65">
                  <c:v>21.3</c:v>
                </c:pt>
                <c:pt idx="66" formatCode="General">
                  <c:v>21.39</c:v>
                </c:pt>
                <c:pt idx="67" formatCode="General">
                  <c:v>21.8</c:v>
                </c:pt>
                <c:pt idx="68" formatCode="General">
                  <c:v>20.78</c:v>
                </c:pt>
                <c:pt idx="69" formatCode="General">
                  <c:v>21.5</c:v>
                </c:pt>
                <c:pt idx="70" formatCode="General">
                  <c:v>21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9F9-46A2-BB1F-D17F7325D8C3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40－49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strRef>
              <c:f>Sheet1!$A$2:$A$72</c:f>
              <c:strCache>
                <c:ptCount val="71"/>
                <c:pt idx="0">
                  <c:v>1947</c:v>
                </c:pt>
                <c:pt idx="1">
                  <c:v>1948</c:v>
                </c:pt>
                <c:pt idx="2">
                  <c:v>1949</c:v>
                </c:pt>
                <c:pt idx="3">
                  <c:v>1950</c:v>
                </c:pt>
                <c:pt idx="4">
                  <c:v>1951</c:v>
                </c:pt>
                <c:pt idx="5">
                  <c:v>1952</c:v>
                </c:pt>
                <c:pt idx="6">
                  <c:v>1953</c:v>
                </c:pt>
                <c:pt idx="7">
                  <c:v>1954</c:v>
                </c:pt>
                <c:pt idx="8">
                  <c:v>1955</c:v>
                </c:pt>
                <c:pt idx="9">
                  <c:v>1956</c:v>
                </c:pt>
                <c:pt idx="10">
                  <c:v>1957</c:v>
                </c:pt>
                <c:pt idx="11">
                  <c:v>1958</c:v>
                </c:pt>
                <c:pt idx="12">
                  <c:v>1959</c:v>
                </c:pt>
                <c:pt idx="13">
                  <c:v>1960</c:v>
                </c:pt>
                <c:pt idx="14">
                  <c:v>1961</c:v>
                </c:pt>
                <c:pt idx="15">
                  <c:v>1962</c:v>
                </c:pt>
                <c:pt idx="16">
                  <c:v>1963</c:v>
                </c:pt>
                <c:pt idx="17">
                  <c:v>1964</c:v>
                </c:pt>
                <c:pt idx="18">
                  <c:v>1965</c:v>
                </c:pt>
                <c:pt idx="19">
                  <c:v>1966</c:v>
                </c:pt>
                <c:pt idx="20">
                  <c:v>1967</c:v>
                </c:pt>
                <c:pt idx="21">
                  <c:v>1968</c:v>
                </c:pt>
                <c:pt idx="22">
                  <c:v>1969</c:v>
                </c:pt>
                <c:pt idx="23">
                  <c:v>1970</c:v>
                </c:pt>
                <c:pt idx="24">
                  <c:v>1971</c:v>
                </c:pt>
                <c:pt idx="25">
                  <c:v>1972</c:v>
                </c:pt>
                <c:pt idx="26">
                  <c:v>1973</c:v>
                </c:pt>
                <c:pt idx="27">
                  <c:v>1974</c:v>
                </c:pt>
                <c:pt idx="28">
                  <c:v>1975</c:v>
                </c:pt>
                <c:pt idx="29">
                  <c:v>1976</c:v>
                </c:pt>
                <c:pt idx="30">
                  <c:v>1977</c:v>
                </c:pt>
                <c:pt idx="31">
                  <c:v>1978</c:v>
                </c:pt>
                <c:pt idx="32">
                  <c:v>1979</c:v>
                </c:pt>
                <c:pt idx="33">
                  <c:v>1980</c:v>
                </c:pt>
                <c:pt idx="34">
                  <c:v>1981</c:v>
                </c:pt>
                <c:pt idx="35">
                  <c:v>1982</c:v>
                </c:pt>
                <c:pt idx="36">
                  <c:v>1983</c:v>
                </c:pt>
                <c:pt idx="37">
                  <c:v>1984</c:v>
                </c:pt>
                <c:pt idx="38">
                  <c:v>1985</c:v>
                </c:pt>
                <c:pt idx="39">
                  <c:v>1986</c:v>
                </c:pt>
                <c:pt idx="40">
                  <c:v>1987</c:v>
                </c:pt>
                <c:pt idx="41">
                  <c:v>1988</c:v>
                </c:pt>
                <c:pt idx="42">
                  <c:v>1989</c:v>
                </c:pt>
                <c:pt idx="43">
                  <c:v>1990</c:v>
                </c:pt>
                <c:pt idx="44">
                  <c:v>1991</c:v>
                </c:pt>
                <c:pt idx="45">
                  <c:v>1992</c:v>
                </c:pt>
                <c:pt idx="46">
                  <c:v>1993</c:v>
                </c:pt>
                <c:pt idx="47">
                  <c:v>1994</c:v>
                </c:pt>
                <c:pt idx="48">
                  <c:v>1995</c:v>
                </c:pt>
                <c:pt idx="49">
                  <c:v>1996</c:v>
                </c:pt>
                <c:pt idx="50">
                  <c:v>1997</c:v>
                </c:pt>
                <c:pt idx="51">
                  <c:v>1998</c:v>
                </c:pt>
                <c:pt idx="52">
                  <c:v>1999</c:v>
                </c:pt>
                <c:pt idx="53">
                  <c:v>2000</c:v>
                </c:pt>
                <c:pt idx="54">
                  <c:v>2001</c:v>
                </c:pt>
                <c:pt idx="55">
                  <c:v>2002</c:v>
                </c:pt>
                <c:pt idx="56">
                  <c:v>2003</c:v>
                </c:pt>
                <c:pt idx="57">
                  <c:v>2004</c:v>
                </c:pt>
                <c:pt idx="58">
                  <c:v>2005</c:v>
                </c:pt>
                <c:pt idx="59">
                  <c:v>2006</c:v>
                </c:pt>
                <c:pt idx="60">
                  <c:v>2007</c:v>
                </c:pt>
                <c:pt idx="61">
                  <c:v>2008</c:v>
                </c:pt>
                <c:pt idx="62">
                  <c:v>2009</c:v>
                </c:pt>
                <c:pt idx="63">
                  <c:v>2010</c:v>
                </c:pt>
                <c:pt idx="64">
                  <c:v>2011</c:v>
                </c:pt>
                <c:pt idx="65">
                  <c:v>2012</c:v>
                </c:pt>
                <c:pt idx="66">
                  <c:v>2013</c:v>
                </c:pt>
                <c:pt idx="67">
                  <c:v>2014</c:v>
                </c:pt>
                <c:pt idx="68">
                  <c:v>2015</c:v>
                </c:pt>
                <c:pt idx="69">
                  <c:v>2016</c:v>
                </c:pt>
                <c:pt idx="70">
                  <c:v>2017</c:v>
                </c:pt>
              </c:strCache>
            </c:strRef>
          </c:cat>
          <c:val>
            <c:numRef>
              <c:f>Sheet1!$D$2:$D$72</c:f>
              <c:numCache>
                <c:formatCode>0.0_);[Red]\(0.0\)</c:formatCode>
                <c:ptCount val="71"/>
                <c:pt idx="0">
                  <c:v>22.050997269656161</c:v>
                </c:pt>
                <c:pt idx="1">
                  <c:v>21.811811793382908</c:v>
                </c:pt>
                <c:pt idx="2">
                  <c:v>22.270062298102658</c:v>
                </c:pt>
                <c:pt idx="3">
                  <c:v>22.117514825610851</c:v>
                </c:pt>
                <c:pt idx="4">
                  <c:v>22.214755851998106</c:v>
                </c:pt>
                <c:pt idx="5">
                  <c:v>22.279035792549305</c:v>
                </c:pt>
                <c:pt idx="6">
                  <c:v>22.359460209441075</c:v>
                </c:pt>
                <c:pt idx="7">
                  <c:v>21.973152469873888</c:v>
                </c:pt>
                <c:pt idx="8">
                  <c:v>22.107623870397994</c:v>
                </c:pt>
                <c:pt idx="9">
                  <c:v>22.229024249226271</c:v>
                </c:pt>
                <c:pt idx="10">
                  <c:v>22.15646929451643</c:v>
                </c:pt>
                <c:pt idx="11">
                  <c:v>22.346926050629754</c:v>
                </c:pt>
                <c:pt idx="12">
                  <c:v>22.28344046525865</c:v>
                </c:pt>
                <c:pt idx="13">
                  <c:v>22.572276943575154</c:v>
                </c:pt>
                <c:pt idx="14">
                  <c:v>22.311105330095963</c:v>
                </c:pt>
                <c:pt idx="15">
                  <c:v>22.41003281309083</c:v>
                </c:pt>
                <c:pt idx="16">
                  <c:v>22.590351338351919</c:v>
                </c:pt>
                <c:pt idx="17">
                  <c:v>22.547879102672059</c:v>
                </c:pt>
                <c:pt idx="18">
                  <c:v>22.599010859363215</c:v>
                </c:pt>
                <c:pt idx="19">
                  <c:v>22.686209649314218</c:v>
                </c:pt>
                <c:pt idx="20">
                  <c:v>22.821529674441621</c:v>
                </c:pt>
                <c:pt idx="21">
                  <c:v>22.906086824171414</c:v>
                </c:pt>
                <c:pt idx="22">
                  <c:v>22.834185053145109</c:v>
                </c:pt>
                <c:pt idx="23">
                  <c:v>23.019916791444231</c:v>
                </c:pt>
                <c:pt idx="24">
                  <c:v>23.155555555555555</c:v>
                </c:pt>
                <c:pt idx="25">
                  <c:v>23.346638550093857</c:v>
                </c:pt>
                <c:pt idx="26">
                  <c:v>23.222701736183925</c:v>
                </c:pt>
                <c:pt idx="28">
                  <c:v>23.13039562650831</c:v>
                </c:pt>
                <c:pt idx="29">
                  <c:v>23.170037856075083</c:v>
                </c:pt>
                <c:pt idx="30">
                  <c:v>23.183141569384961</c:v>
                </c:pt>
                <c:pt idx="31">
                  <c:v>23.239874382363205</c:v>
                </c:pt>
                <c:pt idx="32">
                  <c:v>23.147986995356479</c:v>
                </c:pt>
                <c:pt idx="33">
                  <c:v>23.217221189381355</c:v>
                </c:pt>
                <c:pt idx="34">
                  <c:v>23.242728531855956</c:v>
                </c:pt>
                <c:pt idx="35">
                  <c:v>23.194364028214345</c:v>
                </c:pt>
                <c:pt idx="36">
                  <c:v>23.108139626622467</c:v>
                </c:pt>
                <c:pt idx="37">
                  <c:v>22.961569470572428</c:v>
                </c:pt>
                <c:pt idx="38">
                  <c:v>23.128477837778568</c:v>
                </c:pt>
                <c:pt idx="39">
                  <c:v>23.146199814830403</c:v>
                </c:pt>
                <c:pt idx="40">
                  <c:v>22.92713661878631</c:v>
                </c:pt>
                <c:pt idx="41">
                  <c:v>22.790692739445515</c:v>
                </c:pt>
                <c:pt idx="42">
                  <c:v>22.692928135661212</c:v>
                </c:pt>
                <c:pt idx="43">
                  <c:v>22.77792037586968</c:v>
                </c:pt>
                <c:pt idx="44">
                  <c:v>22.803412543402779</c:v>
                </c:pt>
                <c:pt idx="45">
                  <c:v>22.895935233597569</c:v>
                </c:pt>
                <c:pt idx="46">
                  <c:v>22.903299417434024</c:v>
                </c:pt>
                <c:pt idx="47">
                  <c:v>22.873660728312441</c:v>
                </c:pt>
                <c:pt idx="48">
                  <c:v>22.755679438326478</c:v>
                </c:pt>
                <c:pt idx="49">
                  <c:v>22.81455568652801</c:v>
                </c:pt>
                <c:pt idx="50">
                  <c:v>22.762996572282461</c:v>
                </c:pt>
                <c:pt idx="51">
                  <c:v>22.680071266008209</c:v>
                </c:pt>
                <c:pt idx="52">
                  <c:v>22.481189019774789</c:v>
                </c:pt>
                <c:pt idx="53">
                  <c:v>22.658324009089693</c:v>
                </c:pt>
                <c:pt idx="54">
                  <c:v>22.419466162590727</c:v>
                </c:pt>
                <c:pt idx="55">
                  <c:v>22.472655199472442</c:v>
                </c:pt>
                <c:pt idx="56">
                  <c:v>22.624397297532141</c:v>
                </c:pt>
                <c:pt idx="57">
                  <c:v>22.626079461003727</c:v>
                </c:pt>
                <c:pt idx="58">
                  <c:v>22.410909516867971</c:v>
                </c:pt>
                <c:pt idx="59">
                  <c:v>22.191569637713499</c:v>
                </c:pt>
                <c:pt idx="60">
                  <c:v>21.89</c:v>
                </c:pt>
                <c:pt idx="61">
                  <c:v>22.15</c:v>
                </c:pt>
                <c:pt idx="62">
                  <c:v>22.36</c:v>
                </c:pt>
                <c:pt idx="63">
                  <c:v>21.96</c:v>
                </c:pt>
                <c:pt idx="64">
                  <c:v>22.37</c:v>
                </c:pt>
                <c:pt idx="65">
                  <c:v>21.9</c:v>
                </c:pt>
                <c:pt idx="66" formatCode="General">
                  <c:v>21.91</c:v>
                </c:pt>
                <c:pt idx="67" formatCode="General">
                  <c:v>22.16</c:v>
                </c:pt>
                <c:pt idx="68" formatCode="General">
                  <c:v>22.27</c:v>
                </c:pt>
                <c:pt idx="69" formatCode="General">
                  <c:v>22.3</c:v>
                </c:pt>
                <c:pt idx="70" formatCode="General">
                  <c:v>22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9F9-46A2-BB1F-D17F7325D8C3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50－59</c:v>
                </c:pt>
              </c:strCache>
            </c:strRef>
          </c:tx>
          <c:spPr>
            <a:ln w="12700" cap="rnd">
              <a:solidFill>
                <a:schemeClr val="accent4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Sheet1!$A$2:$A$72</c:f>
              <c:strCache>
                <c:ptCount val="71"/>
                <c:pt idx="0">
                  <c:v>1947</c:v>
                </c:pt>
                <c:pt idx="1">
                  <c:v>1948</c:v>
                </c:pt>
                <c:pt idx="2">
                  <c:v>1949</c:v>
                </c:pt>
                <c:pt idx="3">
                  <c:v>1950</c:v>
                </c:pt>
                <c:pt idx="4">
                  <c:v>1951</c:v>
                </c:pt>
                <c:pt idx="5">
                  <c:v>1952</c:v>
                </c:pt>
                <c:pt idx="6">
                  <c:v>1953</c:v>
                </c:pt>
                <c:pt idx="7">
                  <c:v>1954</c:v>
                </c:pt>
                <c:pt idx="8">
                  <c:v>1955</c:v>
                </c:pt>
                <c:pt idx="9">
                  <c:v>1956</c:v>
                </c:pt>
                <c:pt idx="10">
                  <c:v>1957</c:v>
                </c:pt>
                <c:pt idx="11">
                  <c:v>1958</c:v>
                </c:pt>
                <c:pt idx="12">
                  <c:v>1959</c:v>
                </c:pt>
                <c:pt idx="13">
                  <c:v>1960</c:v>
                </c:pt>
                <c:pt idx="14">
                  <c:v>1961</c:v>
                </c:pt>
                <c:pt idx="15">
                  <c:v>1962</c:v>
                </c:pt>
                <c:pt idx="16">
                  <c:v>1963</c:v>
                </c:pt>
                <c:pt idx="17">
                  <c:v>1964</c:v>
                </c:pt>
                <c:pt idx="18">
                  <c:v>1965</c:v>
                </c:pt>
                <c:pt idx="19">
                  <c:v>1966</c:v>
                </c:pt>
                <c:pt idx="20">
                  <c:v>1967</c:v>
                </c:pt>
                <c:pt idx="21">
                  <c:v>1968</c:v>
                </c:pt>
                <c:pt idx="22">
                  <c:v>1969</c:v>
                </c:pt>
                <c:pt idx="23">
                  <c:v>1970</c:v>
                </c:pt>
                <c:pt idx="24">
                  <c:v>1971</c:v>
                </c:pt>
                <c:pt idx="25">
                  <c:v>1972</c:v>
                </c:pt>
                <c:pt idx="26">
                  <c:v>1973</c:v>
                </c:pt>
                <c:pt idx="27">
                  <c:v>1974</c:v>
                </c:pt>
                <c:pt idx="28">
                  <c:v>1975</c:v>
                </c:pt>
                <c:pt idx="29">
                  <c:v>1976</c:v>
                </c:pt>
                <c:pt idx="30">
                  <c:v>1977</c:v>
                </c:pt>
                <c:pt idx="31">
                  <c:v>1978</c:v>
                </c:pt>
                <c:pt idx="32">
                  <c:v>1979</c:v>
                </c:pt>
                <c:pt idx="33">
                  <c:v>1980</c:v>
                </c:pt>
                <c:pt idx="34">
                  <c:v>1981</c:v>
                </c:pt>
                <c:pt idx="35">
                  <c:v>1982</c:v>
                </c:pt>
                <c:pt idx="36">
                  <c:v>1983</c:v>
                </c:pt>
                <c:pt idx="37">
                  <c:v>1984</c:v>
                </c:pt>
                <c:pt idx="38">
                  <c:v>1985</c:v>
                </c:pt>
                <c:pt idx="39">
                  <c:v>1986</c:v>
                </c:pt>
                <c:pt idx="40">
                  <c:v>1987</c:v>
                </c:pt>
                <c:pt idx="41">
                  <c:v>1988</c:v>
                </c:pt>
                <c:pt idx="42">
                  <c:v>1989</c:v>
                </c:pt>
                <c:pt idx="43">
                  <c:v>1990</c:v>
                </c:pt>
                <c:pt idx="44">
                  <c:v>1991</c:v>
                </c:pt>
                <c:pt idx="45">
                  <c:v>1992</c:v>
                </c:pt>
                <c:pt idx="46">
                  <c:v>1993</c:v>
                </c:pt>
                <c:pt idx="47">
                  <c:v>1994</c:v>
                </c:pt>
                <c:pt idx="48">
                  <c:v>1995</c:v>
                </c:pt>
                <c:pt idx="49">
                  <c:v>1996</c:v>
                </c:pt>
                <c:pt idx="50">
                  <c:v>1997</c:v>
                </c:pt>
                <c:pt idx="51">
                  <c:v>1998</c:v>
                </c:pt>
                <c:pt idx="52">
                  <c:v>1999</c:v>
                </c:pt>
                <c:pt idx="53">
                  <c:v>2000</c:v>
                </c:pt>
                <c:pt idx="54">
                  <c:v>2001</c:v>
                </c:pt>
                <c:pt idx="55">
                  <c:v>2002</c:v>
                </c:pt>
                <c:pt idx="56">
                  <c:v>2003</c:v>
                </c:pt>
                <c:pt idx="57">
                  <c:v>2004</c:v>
                </c:pt>
                <c:pt idx="58">
                  <c:v>2005</c:v>
                </c:pt>
                <c:pt idx="59">
                  <c:v>2006</c:v>
                </c:pt>
                <c:pt idx="60">
                  <c:v>2007</c:v>
                </c:pt>
                <c:pt idx="61">
                  <c:v>2008</c:v>
                </c:pt>
                <c:pt idx="62">
                  <c:v>2009</c:v>
                </c:pt>
                <c:pt idx="63">
                  <c:v>2010</c:v>
                </c:pt>
                <c:pt idx="64">
                  <c:v>2011</c:v>
                </c:pt>
                <c:pt idx="65">
                  <c:v>2012</c:v>
                </c:pt>
                <c:pt idx="66">
                  <c:v>2013</c:v>
                </c:pt>
                <c:pt idx="67">
                  <c:v>2014</c:v>
                </c:pt>
                <c:pt idx="68">
                  <c:v>2015</c:v>
                </c:pt>
                <c:pt idx="69">
                  <c:v>2016</c:v>
                </c:pt>
                <c:pt idx="70">
                  <c:v>2017</c:v>
                </c:pt>
              </c:strCache>
            </c:strRef>
          </c:cat>
          <c:val>
            <c:numRef>
              <c:f>Sheet1!$E$2:$E$72</c:f>
              <c:numCache>
                <c:formatCode>0.0_);[Red]\(0.0\)</c:formatCode>
                <c:ptCount val="71"/>
                <c:pt idx="0">
                  <c:v>21.360163436898478</c:v>
                </c:pt>
                <c:pt idx="1">
                  <c:v>21.863867588455506</c:v>
                </c:pt>
                <c:pt idx="2">
                  <c:v>22.040363245592285</c:v>
                </c:pt>
                <c:pt idx="3">
                  <c:v>21.903734284105838</c:v>
                </c:pt>
                <c:pt idx="4">
                  <c:v>22.033684035744479</c:v>
                </c:pt>
                <c:pt idx="5">
                  <c:v>22.033046290010734</c:v>
                </c:pt>
                <c:pt idx="6">
                  <c:v>22.300194345700454</c:v>
                </c:pt>
                <c:pt idx="7">
                  <c:v>21.981795676850624</c:v>
                </c:pt>
                <c:pt idx="8">
                  <c:v>21.961053282640453</c:v>
                </c:pt>
                <c:pt idx="9">
                  <c:v>22.136630966470257</c:v>
                </c:pt>
                <c:pt idx="10">
                  <c:v>22.15016858583261</c:v>
                </c:pt>
                <c:pt idx="11">
                  <c:v>22.283436352235061</c:v>
                </c:pt>
                <c:pt idx="12">
                  <c:v>22.027858762552643</c:v>
                </c:pt>
                <c:pt idx="13">
                  <c:v>22.277754639270672</c:v>
                </c:pt>
                <c:pt idx="14">
                  <c:v>22.148178999490952</c:v>
                </c:pt>
                <c:pt idx="15">
                  <c:v>22.491756082872488</c:v>
                </c:pt>
                <c:pt idx="16">
                  <c:v>22.608064893246848</c:v>
                </c:pt>
                <c:pt idx="17">
                  <c:v>22.661816291343293</c:v>
                </c:pt>
                <c:pt idx="18">
                  <c:v>22.722595023948806</c:v>
                </c:pt>
                <c:pt idx="19">
                  <c:v>22.626332265122308</c:v>
                </c:pt>
                <c:pt idx="20">
                  <c:v>22.889760226675826</c:v>
                </c:pt>
                <c:pt idx="21">
                  <c:v>22.928282211637757</c:v>
                </c:pt>
                <c:pt idx="22">
                  <c:v>22.948325572491832</c:v>
                </c:pt>
                <c:pt idx="23">
                  <c:v>23.044550678940141</c:v>
                </c:pt>
                <c:pt idx="24">
                  <c:v>23.069617814851277</c:v>
                </c:pt>
                <c:pt idx="25">
                  <c:v>23.6894741891584</c:v>
                </c:pt>
                <c:pt idx="26">
                  <c:v>23.203478614656969</c:v>
                </c:pt>
                <c:pt idx="28">
                  <c:v>23.363632386324422</c:v>
                </c:pt>
                <c:pt idx="29">
                  <c:v>23.435943179758183</c:v>
                </c:pt>
                <c:pt idx="30">
                  <c:v>23.279547599302241</c:v>
                </c:pt>
                <c:pt idx="31">
                  <c:v>23.431521713807481</c:v>
                </c:pt>
                <c:pt idx="32">
                  <c:v>23.131732307244889</c:v>
                </c:pt>
                <c:pt idx="33">
                  <c:v>23.265958993747272</c:v>
                </c:pt>
                <c:pt idx="34">
                  <c:v>23.382324658223151</c:v>
                </c:pt>
                <c:pt idx="35">
                  <c:v>23.568564772052923</c:v>
                </c:pt>
                <c:pt idx="36">
                  <c:v>23.453483109264305</c:v>
                </c:pt>
                <c:pt idx="37">
                  <c:v>23.29780160706202</c:v>
                </c:pt>
                <c:pt idx="38">
                  <c:v>23.492866147400452</c:v>
                </c:pt>
                <c:pt idx="39">
                  <c:v>23.355150605401708</c:v>
                </c:pt>
                <c:pt idx="40">
                  <c:v>23.518843368039839</c:v>
                </c:pt>
                <c:pt idx="41">
                  <c:v>23.363244434431628</c:v>
                </c:pt>
                <c:pt idx="42">
                  <c:v>23.257637243054575</c:v>
                </c:pt>
                <c:pt idx="43">
                  <c:v>23.427315988685088</c:v>
                </c:pt>
                <c:pt idx="44">
                  <c:v>23.427315988685088</c:v>
                </c:pt>
                <c:pt idx="45">
                  <c:v>23.514568562199738</c:v>
                </c:pt>
                <c:pt idx="46">
                  <c:v>23.273341276029196</c:v>
                </c:pt>
                <c:pt idx="47">
                  <c:v>23.298627455811495</c:v>
                </c:pt>
                <c:pt idx="48">
                  <c:v>23.298627455811495</c:v>
                </c:pt>
                <c:pt idx="49">
                  <c:v>23.232085528429032</c:v>
                </c:pt>
                <c:pt idx="50">
                  <c:v>23.354881704957691</c:v>
                </c:pt>
                <c:pt idx="51">
                  <c:v>23.299799895836184</c:v>
                </c:pt>
                <c:pt idx="52">
                  <c:v>23.324362424708443</c:v>
                </c:pt>
                <c:pt idx="53">
                  <c:v>23.007860166747342</c:v>
                </c:pt>
                <c:pt idx="54">
                  <c:v>23.202881576912027</c:v>
                </c:pt>
                <c:pt idx="55">
                  <c:v>23.135681612118159</c:v>
                </c:pt>
                <c:pt idx="56">
                  <c:v>22.985401518560394</c:v>
                </c:pt>
                <c:pt idx="57">
                  <c:v>22.957447031346554</c:v>
                </c:pt>
                <c:pt idx="58">
                  <c:v>23.053274401744524</c:v>
                </c:pt>
                <c:pt idx="59">
                  <c:v>23.04123333438066</c:v>
                </c:pt>
                <c:pt idx="60">
                  <c:v>22.93</c:v>
                </c:pt>
                <c:pt idx="61">
                  <c:v>22.6</c:v>
                </c:pt>
                <c:pt idx="62">
                  <c:v>22.55</c:v>
                </c:pt>
                <c:pt idx="63">
                  <c:v>22.5</c:v>
                </c:pt>
                <c:pt idx="64">
                  <c:v>22.75</c:v>
                </c:pt>
                <c:pt idx="65">
                  <c:v>22.6</c:v>
                </c:pt>
                <c:pt idx="66" formatCode="General">
                  <c:v>22.74</c:v>
                </c:pt>
                <c:pt idx="67" formatCode="General">
                  <c:v>22.65</c:v>
                </c:pt>
                <c:pt idx="68" formatCode="General">
                  <c:v>22.41</c:v>
                </c:pt>
                <c:pt idx="69" formatCode="General">
                  <c:v>22.5</c:v>
                </c:pt>
                <c:pt idx="70" formatCode="General">
                  <c:v>22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49F9-46A2-BB1F-D17F7325D8C3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60－69</c:v>
                </c:pt>
              </c:strCache>
            </c:strRef>
          </c:tx>
          <c:spPr>
            <a:ln w="12700" cap="rnd">
              <a:solidFill>
                <a:schemeClr val="accent4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cat>
            <c:strRef>
              <c:f>Sheet1!$A$2:$A$72</c:f>
              <c:strCache>
                <c:ptCount val="71"/>
                <c:pt idx="0">
                  <c:v>1947</c:v>
                </c:pt>
                <c:pt idx="1">
                  <c:v>1948</c:v>
                </c:pt>
                <c:pt idx="2">
                  <c:v>1949</c:v>
                </c:pt>
                <c:pt idx="3">
                  <c:v>1950</c:v>
                </c:pt>
                <c:pt idx="4">
                  <c:v>1951</c:v>
                </c:pt>
                <c:pt idx="5">
                  <c:v>1952</c:v>
                </c:pt>
                <c:pt idx="6">
                  <c:v>1953</c:v>
                </c:pt>
                <c:pt idx="7">
                  <c:v>1954</c:v>
                </c:pt>
                <c:pt idx="8">
                  <c:v>1955</c:v>
                </c:pt>
                <c:pt idx="9">
                  <c:v>1956</c:v>
                </c:pt>
                <c:pt idx="10">
                  <c:v>1957</c:v>
                </c:pt>
                <c:pt idx="11">
                  <c:v>1958</c:v>
                </c:pt>
                <c:pt idx="12">
                  <c:v>1959</c:v>
                </c:pt>
                <c:pt idx="13">
                  <c:v>1960</c:v>
                </c:pt>
                <c:pt idx="14">
                  <c:v>1961</c:v>
                </c:pt>
                <c:pt idx="15">
                  <c:v>1962</c:v>
                </c:pt>
                <c:pt idx="16">
                  <c:v>1963</c:v>
                </c:pt>
                <c:pt idx="17">
                  <c:v>1964</c:v>
                </c:pt>
                <c:pt idx="18">
                  <c:v>1965</c:v>
                </c:pt>
                <c:pt idx="19">
                  <c:v>1966</c:v>
                </c:pt>
                <c:pt idx="20">
                  <c:v>1967</c:v>
                </c:pt>
                <c:pt idx="21">
                  <c:v>1968</c:v>
                </c:pt>
                <c:pt idx="22">
                  <c:v>1969</c:v>
                </c:pt>
                <c:pt idx="23">
                  <c:v>1970</c:v>
                </c:pt>
                <c:pt idx="24">
                  <c:v>1971</c:v>
                </c:pt>
                <c:pt idx="25">
                  <c:v>1972</c:v>
                </c:pt>
                <c:pt idx="26">
                  <c:v>1973</c:v>
                </c:pt>
                <c:pt idx="27">
                  <c:v>1974</c:v>
                </c:pt>
                <c:pt idx="28">
                  <c:v>1975</c:v>
                </c:pt>
                <c:pt idx="29">
                  <c:v>1976</c:v>
                </c:pt>
                <c:pt idx="30">
                  <c:v>1977</c:v>
                </c:pt>
                <c:pt idx="31">
                  <c:v>1978</c:v>
                </c:pt>
                <c:pt idx="32">
                  <c:v>1979</c:v>
                </c:pt>
                <c:pt idx="33">
                  <c:v>1980</c:v>
                </c:pt>
                <c:pt idx="34">
                  <c:v>1981</c:v>
                </c:pt>
                <c:pt idx="35">
                  <c:v>1982</c:v>
                </c:pt>
                <c:pt idx="36">
                  <c:v>1983</c:v>
                </c:pt>
                <c:pt idx="37">
                  <c:v>1984</c:v>
                </c:pt>
                <c:pt idx="38">
                  <c:v>1985</c:v>
                </c:pt>
                <c:pt idx="39">
                  <c:v>1986</c:v>
                </c:pt>
                <c:pt idx="40">
                  <c:v>1987</c:v>
                </c:pt>
                <c:pt idx="41">
                  <c:v>1988</c:v>
                </c:pt>
                <c:pt idx="42">
                  <c:v>1989</c:v>
                </c:pt>
                <c:pt idx="43">
                  <c:v>1990</c:v>
                </c:pt>
                <c:pt idx="44">
                  <c:v>1991</c:v>
                </c:pt>
                <c:pt idx="45">
                  <c:v>1992</c:v>
                </c:pt>
                <c:pt idx="46">
                  <c:v>1993</c:v>
                </c:pt>
                <c:pt idx="47">
                  <c:v>1994</c:v>
                </c:pt>
                <c:pt idx="48">
                  <c:v>1995</c:v>
                </c:pt>
                <c:pt idx="49">
                  <c:v>1996</c:v>
                </c:pt>
                <c:pt idx="50">
                  <c:v>1997</c:v>
                </c:pt>
                <c:pt idx="51">
                  <c:v>1998</c:v>
                </c:pt>
                <c:pt idx="52">
                  <c:v>1999</c:v>
                </c:pt>
                <c:pt idx="53">
                  <c:v>2000</c:v>
                </c:pt>
                <c:pt idx="54">
                  <c:v>2001</c:v>
                </c:pt>
                <c:pt idx="55">
                  <c:v>2002</c:v>
                </c:pt>
                <c:pt idx="56">
                  <c:v>2003</c:v>
                </c:pt>
                <c:pt idx="57">
                  <c:v>2004</c:v>
                </c:pt>
                <c:pt idx="58">
                  <c:v>2005</c:v>
                </c:pt>
                <c:pt idx="59">
                  <c:v>2006</c:v>
                </c:pt>
                <c:pt idx="60">
                  <c:v>2007</c:v>
                </c:pt>
                <c:pt idx="61">
                  <c:v>2008</c:v>
                </c:pt>
                <c:pt idx="62">
                  <c:v>2009</c:v>
                </c:pt>
                <c:pt idx="63">
                  <c:v>2010</c:v>
                </c:pt>
                <c:pt idx="64">
                  <c:v>2011</c:v>
                </c:pt>
                <c:pt idx="65">
                  <c:v>2012</c:v>
                </c:pt>
                <c:pt idx="66">
                  <c:v>2013</c:v>
                </c:pt>
                <c:pt idx="67">
                  <c:v>2014</c:v>
                </c:pt>
                <c:pt idx="68">
                  <c:v>2015</c:v>
                </c:pt>
                <c:pt idx="69">
                  <c:v>2016</c:v>
                </c:pt>
                <c:pt idx="70">
                  <c:v>2017</c:v>
                </c:pt>
              </c:strCache>
            </c:strRef>
          </c:cat>
          <c:val>
            <c:numRef>
              <c:f>Sheet1!$F$2:$F$72</c:f>
              <c:numCache>
                <c:formatCode>0.0_);[Red]\(0.0\)</c:formatCode>
                <c:ptCount val="71"/>
                <c:pt idx="0">
                  <c:v>21.047105682085459</c:v>
                </c:pt>
                <c:pt idx="1">
                  <c:v>21.46663649698824</c:v>
                </c:pt>
                <c:pt idx="2">
                  <c:v>21.646086246383593</c:v>
                </c:pt>
                <c:pt idx="3">
                  <c:v>21.534506471474632</c:v>
                </c:pt>
                <c:pt idx="4">
                  <c:v>21.928532366133929</c:v>
                </c:pt>
                <c:pt idx="5">
                  <c:v>21.526725023228522</c:v>
                </c:pt>
                <c:pt idx="6">
                  <c:v>21.653777513384888</c:v>
                </c:pt>
                <c:pt idx="7">
                  <c:v>21.57607837900181</c:v>
                </c:pt>
                <c:pt idx="8">
                  <c:v>21.552688347737451</c:v>
                </c:pt>
                <c:pt idx="9">
                  <c:v>21.491848061641608</c:v>
                </c:pt>
                <c:pt idx="10">
                  <c:v>21.869577703103534</c:v>
                </c:pt>
                <c:pt idx="11">
                  <c:v>21.937375331058242</c:v>
                </c:pt>
                <c:pt idx="12">
                  <c:v>21.817129629629633</c:v>
                </c:pt>
                <c:pt idx="13">
                  <c:v>22.091498182974274</c:v>
                </c:pt>
                <c:pt idx="14">
                  <c:v>22.072288184554292</c:v>
                </c:pt>
                <c:pt idx="15">
                  <c:v>22.239056949203128</c:v>
                </c:pt>
                <c:pt idx="16">
                  <c:v>22.143405091357089</c:v>
                </c:pt>
                <c:pt idx="17">
                  <c:v>22.169274793165791</c:v>
                </c:pt>
                <c:pt idx="18">
                  <c:v>22.392288086444246</c:v>
                </c:pt>
                <c:pt idx="19">
                  <c:v>22.208981611268044</c:v>
                </c:pt>
                <c:pt idx="20">
                  <c:v>22.563159772025291</c:v>
                </c:pt>
                <c:pt idx="21">
                  <c:v>22.610591261981199</c:v>
                </c:pt>
                <c:pt idx="22">
                  <c:v>22.508430003850872</c:v>
                </c:pt>
                <c:pt idx="23">
                  <c:v>22.646910095399107</c:v>
                </c:pt>
                <c:pt idx="24">
                  <c:v>22.734839476813317</c:v>
                </c:pt>
                <c:pt idx="25">
                  <c:v>22.924994397939379</c:v>
                </c:pt>
                <c:pt idx="26">
                  <c:v>23.066734090085738</c:v>
                </c:pt>
                <c:pt idx="28">
                  <c:v>22.909121062758345</c:v>
                </c:pt>
                <c:pt idx="29">
                  <c:v>23.171887010528785</c:v>
                </c:pt>
                <c:pt idx="30">
                  <c:v>23.07882722333791</c:v>
                </c:pt>
                <c:pt idx="31">
                  <c:v>23.141927199976109</c:v>
                </c:pt>
                <c:pt idx="32">
                  <c:v>22.968415886379827</c:v>
                </c:pt>
                <c:pt idx="33">
                  <c:v>22.952175133392227</c:v>
                </c:pt>
                <c:pt idx="34">
                  <c:v>23.138507103521679</c:v>
                </c:pt>
                <c:pt idx="35">
                  <c:v>23.306430174858225</c:v>
                </c:pt>
                <c:pt idx="36">
                  <c:v>23.381304897739007</c:v>
                </c:pt>
                <c:pt idx="37">
                  <c:v>23.272082314319078</c:v>
                </c:pt>
                <c:pt idx="38">
                  <c:v>23.483806702177716</c:v>
                </c:pt>
                <c:pt idx="39">
                  <c:v>23.283418553688822</c:v>
                </c:pt>
                <c:pt idx="40">
                  <c:v>23.466033601168739</c:v>
                </c:pt>
                <c:pt idx="41">
                  <c:v>23.294294577923726</c:v>
                </c:pt>
                <c:pt idx="42">
                  <c:v>23.416658747440646</c:v>
                </c:pt>
                <c:pt idx="43">
                  <c:v>23.503348434649826</c:v>
                </c:pt>
                <c:pt idx="44">
                  <c:v>23.489666587309681</c:v>
                </c:pt>
                <c:pt idx="45">
                  <c:v>23.60254042610693</c:v>
                </c:pt>
                <c:pt idx="46">
                  <c:v>23.814667760577795</c:v>
                </c:pt>
                <c:pt idx="47">
                  <c:v>23.386719569039208</c:v>
                </c:pt>
                <c:pt idx="48">
                  <c:v>23.610730292880582</c:v>
                </c:pt>
                <c:pt idx="49">
                  <c:v>23.586994398311347</c:v>
                </c:pt>
                <c:pt idx="50">
                  <c:v>23.592324630386912</c:v>
                </c:pt>
                <c:pt idx="51">
                  <c:v>23.688888888888886</c:v>
                </c:pt>
                <c:pt idx="52">
                  <c:v>23.620048343837265</c:v>
                </c:pt>
                <c:pt idx="53">
                  <c:v>23.632781842968985</c:v>
                </c:pt>
                <c:pt idx="54">
                  <c:v>23.469330692556614</c:v>
                </c:pt>
                <c:pt idx="55">
                  <c:v>23.702059396745202</c:v>
                </c:pt>
                <c:pt idx="56">
                  <c:v>23.531749097692078</c:v>
                </c:pt>
                <c:pt idx="57">
                  <c:v>23.383689701927761</c:v>
                </c:pt>
                <c:pt idx="58">
                  <c:v>23.54566220318377</c:v>
                </c:pt>
                <c:pt idx="59">
                  <c:v>23.383689701927761</c:v>
                </c:pt>
                <c:pt idx="60">
                  <c:v>23.28</c:v>
                </c:pt>
                <c:pt idx="61">
                  <c:v>23.03</c:v>
                </c:pt>
                <c:pt idx="62">
                  <c:v>23.05</c:v>
                </c:pt>
                <c:pt idx="63">
                  <c:v>23.17</c:v>
                </c:pt>
                <c:pt idx="64">
                  <c:v>22.86</c:v>
                </c:pt>
                <c:pt idx="65">
                  <c:v>22.8</c:v>
                </c:pt>
                <c:pt idx="66" formatCode="General">
                  <c:v>22.64</c:v>
                </c:pt>
                <c:pt idx="67" formatCode="General">
                  <c:v>22.82</c:v>
                </c:pt>
                <c:pt idx="68" formatCode="General">
                  <c:v>22.69</c:v>
                </c:pt>
                <c:pt idx="69" formatCode="General">
                  <c:v>22.9</c:v>
                </c:pt>
                <c:pt idx="70" formatCode="General">
                  <c:v>23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49F9-46A2-BB1F-D17F7325D8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03508448"/>
        <c:axId val="303501920"/>
      </c:lineChart>
      <c:catAx>
        <c:axId val="303508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03501920"/>
        <c:crosses val="autoZero"/>
        <c:auto val="1"/>
        <c:lblAlgn val="ctr"/>
        <c:lblOffset val="100"/>
        <c:noMultiLvlLbl val="0"/>
      </c:catAx>
      <c:valAx>
        <c:axId val="303501920"/>
        <c:scaling>
          <c:orientation val="minMax"/>
          <c:min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_);[Red]\(0.0\)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035084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0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099" name="Rectangle 1027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1543" y="0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100" name="Rectangle 1028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1" y="9430387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101" name="Rectangle 1029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1543" y="9430387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fld id="{F04146FC-D5C5-4BA4-8C1B-5F38138DDB21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41296642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7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2" y="1"/>
            <a:ext cx="2922350" cy="459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7817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45199" y="1"/>
            <a:ext cx="2922349" cy="459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55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69963" y="765175"/>
            <a:ext cx="4905375" cy="36798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7818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22849" y="4751660"/>
            <a:ext cx="4997963" cy="44456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17818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2" y="9427217"/>
            <a:ext cx="2922350" cy="535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7818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5199" y="9427217"/>
            <a:ext cx="2922349" cy="535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fld id="{F3A0F74B-D64D-415A-BCE6-EF678DD9050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8279022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0113" y="2997200"/>
            <a:ext cx="7848600" cy="9032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76" name="Rectangle 4"/>
          <p:cNvSpPr>
            <a:spLocks noGrp="1" noChangeArrowheads="1"/>
          </p:cNvSpPr>
          <p:nvPr>
            <p:ph type="ctrTitle"/>
          </p:nvPr>
        </p:nvSpPr>
        <p:spPr>
          <a:xfrm>
            <a:off x="683568" y="1772816"/>
            <a:ext cx="7772400" cy="1470025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ja-JP" altLang="en-US" noProof="0"/>
              <a:t>マスター タイトルの書式設定</a:t>
            </a:r>
          </a:p>
        </p:txBody>
      </p:sp>
      <p:sp>
        <p:nvSpPr>
          <p:cNvPr id="3077" name="Rectangle 5"/>
          <p:cNvSpPr>
            <a:spLocks noGrp="1" noChangeArrowheads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FontTx/>
              <a:buNone/>
              <a:defRPr sz="2800"/>
            </a:lvl1pPr>
          </a:lstStyle>
          <a:p>
            <a:pPr lvl="0"/>
            <a:r>
              <a:rPr lang="ja-JP" altLang="en-US" noProof="0"/>
              <a:t>マスター サブタイトルの書式設定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dt" sz="half" idx="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ftr" sz="quarter" idx="3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3080" name="Rectangle 8"/>
          <p:cNvSpPr>
            <a:spLocks noGrp="1" noChangeArrowheads="1"/>
          </p:cNvSpPr>
          <p:nvPr>
            <p:ph type="sldNum" sz="quarter" idx="4"/>
          </p:nvPr>
        </p:nvSpPr>
        <p:spPr/>
        <p:txBody>
          <a:bodyPr/>
          <a:lstStyle>
            <a:lvl1pPr>
              <a:defRPr/>
            </a:lvl1pPr>
          </a:lstStyle>
          <a:p>
            <a:fld id="{8630D260-68D9-45D3-9739-E526F76B7E3B}" type="slidenum">
              <a:rPr lang="en-US" altLang="ja-JP">
                <a:solidFill>
                  <a:prstClr val="black"/>
                </a:solidFill>
              </a:rPr>
              <a:pPr/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646607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44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44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276896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タイトル、テキスト、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7818"/>
            <a:ext cx="8229600" cy="11398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sz="half" idx="1"/>
          </p:nvPr>
        </p:nvSpPr>
        <p:spPr>
          <a:xfrm>
            <a:off x="457203" y="1600206"/>
            <a:ext cx="4044462" cy="45307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2338" y="1600206"/>
            <a:ext cx="4044462" cy="45307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1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Rectangle 1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Rectangle 14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12C04E-7F54-4F85-815C-28C6CA88C1E5}" type="slidenum">
              <a:rPr lang="en-US" altLang="ja-JP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78F18A-7940-4825-A94E-9EF05EBD0DED}" type="datetimeFigureOut">
              <a:rPr lang="ja-JP" altLang="en-US">
                <a:solidFill>
                  <a:srgbClr val="000000"/>
                </a:solidFill>
              </a:rPr>
              <a:pPr>
                <a:defRPr/>
              </a:pPr>
              <a:t>2020/5/15</a:t>
            </a:fld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7BC907-18D2-432F-A78E-ECA81781537A}" type="slidenum">
              <a:rPr lang="ja-JP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2361942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E9E679D-BAB8-4293-97BD-26CC0F07242E}" type="datetimeFigureOut">
              <a:rPr lang="ja-JP" altLang="en-US">
                <a:solidFill>
                  <a:srgbClr val="000000"/>
                </a:solidFill>
              </a:rPr>
              <a:pPr>
                <a:defRPr/>
              </a:pPr>
              <a:t>2020/5/15</a:t>
            </a:fld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4A3D87-7195-4A33-A2DE-143149D8E65C}" type="slidenum">
              <a:rPr lang="ja-JP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6516411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349CD95-B73F-4EFB-BA21-BFBF32E4E1E3}" type="datetimeFigureOut">
              <a:rPr lang="ja-JP" altLang="en-US">
                <a:solidFill>
                  <a:srgbClr val="000000"/>
                </a:solidFill>
              </a:rPr>
              <a:pPr>
                <a:defRPr/>
              </a:pPr>
              <a:t>2020/5/15</a:t>
            </a:fld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BCBD66-2909-4FA8-BBCF-AB547C221729}" type="slidenum">
              <a:rPr lang="ja-JP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4304615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DED0327-1DE2-4358-B1F4-552F32191B43}" type="datetimeFigureOut">
              <a:rPr lang="ja-JP" altLang="en-US">
                <a:solidFill>
                  <a:srgbClr val="000000"/>
                </a:solidFill>
              </a:rPr>
              <a:pPr>
                <a:defRPr/>
              </a:pPr>
              <a:t>2020/5/15</a:t>
            </a:fld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3BFE5CE-CDC9-49B7-B48F-6642BC6831C6}" type="slidenum">
              <a:rPr lang="ja-JP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5311884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E4A8AF6-9A30-4957-A2C4-5DFB29401C8A}" type="datetimeFigureOut">
              <a:rPr lang="ja-JP" altLang="en-US">
                <a:solidFill>
                  <a:srgbClr val="000000"/>
                </a:solidFill>
              </a:rPr>
              <a:pPr>
                <a:defRPr/>
              </a:pPr>
              <a:t>2020/5/15</a:t>
            </a:fld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3E5F5F-A2A2-4E3C-BBDC-E71991762CE2}" type="slidenum">
              <a:rPr lang="ja-JP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9412531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731AAEB-754E-4F56-986D-478094A015DB}" type="datetimeFigureOut">
              <a:rPr lang="ja-JP" altLang="en-US">
                <a:solidFill>
                  <a:srgbClr val="000000"/>
                </a:solidFill>
              </a:rPr>
              <a:pPr>
                <a:defRPr/>
              </a:pPr>
              <a:t>2020/5/15</a:t>
            </a:fld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1D10BC-A9E2-4D9C-B3A0-093BF1C574B5}" type="slidenum">
              <a:rPr lang="ja-JP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0395540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83F39C3-EE34-4875-9DA5-8D356EC51F32}" type="datetimeFigureOut">
              <a:rPr lang="ja-JP" altLang="en-US">
                <a:solidFill>
                  <a:srgbClr val="000000"/>
                </a:solidFill>
              </a:rPr>
              <a:pPr>
                <a:defRPr/>
              </a:pPr>
              <a:t>2020/5/15</a:t>
            </a:fld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DBA01EB-E328-4D75-AF55-6E1A81E352CC}" type="slidenum">
              <a:rPr lang="ja-JP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59245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126D4F-3EDC-4F67-81E1-7E3B730BC726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1923113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FD055BC-B611-462D-95DD-D65E602A507B}" type="datetimeFigureOut">
              <a:rPr lang="ja-JP" altLang="en-US">
                <a:solidFill>
                  <a:srgbClr val="000000"/>
                </a:solidFill>
              </a:rPr>
              <a:pPr>
                <a:defRPr/>
              </a:pPr>
              <a:t>2020/5/15</a:t>
            </a:fld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F8E99C0-4CFE-4E44-8FC6-0CE2DA927421}" type="slidenum">
              <a:rPr lang="ja-JP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1067860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22943CB-C658-4D51-A71B-8A5366154663}" type="datetimeFigureOut">
              <a:rPr lang="ja-JP" altLang="en-US">
                <a:solidFill>
                  <a:srgbClr val="000000"/>
                </a:solidFill>
              </a:rPr>
              <a:pPr>
                <a:defRPr/>
              </a:pPr>
              <a:t>2020/5/15</a:t>
            </a:fld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875D90A-ADE7-429B-9EA7-4D0A0A080D20}" type="slidenum">
              <a:rPr lang="ja-JP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4686421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6C6EF3B-03CE-43A2-A0A5-A27C1F57F61D}" type="datetimeFigureOut">
              <a:rPr lang="ja-JP" altLang="en-US">
                <a:solidFill>
                  <a:srgbClr val="000000"/>
                </a:solidFill>
              </a:rPr>
              <a:pPr>
                <a:defRPr/>
              </a:pPr>
              <a:t>2020/5/15</a:t>
            </a:fld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D1E683-FDB1-4FBF-A673-774DAD56EC13}" type="slidenum">
              <a:rPr lang="ja-JP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54300958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68CE679-1B9B-4449-BF82-89174722B85B}" type="datetimeFigureOut">
              <a:rPr lang="ja-JP" altLang="en-US">
                <a:solidFill>
                  <a:srgbClr val="000000"/>
                </a:solidFill>
              </a:rPr>
              <a:pPr>
                <a:defRPr/>
              </a:pPr>
              <a:t>2020/5/15</a:t>
            </a:fld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F27DF28-6F40-4155-A31A-483806FB8A73}" type="slidenum">
              <a:rPr lang="ja-JP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34609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6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FB67A0-E466-4A89-B796-1312CC8BDE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13623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27088" y="1773243"/>
            <a:ext cx="3852862" cy="4352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832350" y="1773243"/>
            <a:ext cx="3854450" cy="4352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7FABE6-EE91-4374-8988-8639AC3FF2BA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60904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426A84-590D-4994-AD3B-BF3EBB6C2AF1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88644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E63697-0A4E-4916-BEB4-6D0ABB3B2E5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35224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82F1FB-B130-4DC9-947D-26E8A4BB2D4C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1503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1" y="273056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36034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700CEC-AB21-4C70-A4C5-0E6288EFC26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1726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2.jpeg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1.pn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950" y="620716"/>
            <a:ext cx="754063" cy="5876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827088" y="1773242"/>
            <a:ext cx="7859712" cy="4352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+mn-lt"/>
                <a:ea typeface="+mn-ea"/>
                <a:cs typeface="+mn-cs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+mn-lt"/>
                <a:ea typeface="+mn-ea"/>
                <a:cs typeface="+mn-cs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+mn-lt"/>
                <a:ea typeface="+mn-ea"/>
                <a:cs typeface="+mn-cs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31" r:id="rId1"/>
    <p:sldLayoutId id="2147483932" r:id="rId2"/>
    <p:sldLayoutId id="2147483933" r:id="rId3"/>
    <p:sldLayoutId id="2147483934" r:id="rId4"/>
    <p:sldLayoutId id="2147483935" r:id="rId5"/>
    <p:sldLayoutId id="2147483936" r:id="rId6"/>
    <p:sldLayoutId id="2147483937" r:id="rId7"/>
    <p:sldLayoutId id="2147483938" r:id="rId8"/>
    <p:sldLayoutId id="2147483939" r:id="rId9"/>
    <p:sldLayoutId id="2147483940" r:id="rId10"/>
    <p:sldLayoutId id="2147483941" r:id="rId11"/>
    <p:sldLayoutId id="2147483942" r:id="rId12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8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4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404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fld id="{FAED3834-019A-42B2-9D8C-DD2012D2D8E7}" type="datetimeFigureOut">
              <a:rPr lang="ja-JP" altLang="en-US">
                <a:solidFill>
                  <a:srgbClr val="000000"/>
                </a:solidFill>
                <a:latin typeface="Arial"/>
                <a:ea typeface="ＭＳ Ｐゴシック"/>
              </a:rPr>
              <a:pPr>
                <a:defRPr/>
              </a:pPr>
              <a:t>2020/5/15</a:t>
            </a:fld>
            <a:endParaRPr lang="en-US" altLang="ja-JP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  <p:sp>
        <p:nvSpPr>
          <p:cNvPr id="102405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  <p:sp>
        <p:nvSpPr>
          <p:cNvPr id="102406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041B931D-5D92-4500-9E53-4C80EAC7C349}" type="slidenum">
              <a:rPr lang="ja-JP" altLang="en-US">
                <a:solidFill>
                  <a:srgbClr val="000000"/>
                </a:solidFill>
                <a:latin typeface="Arial"/>
                <a:ea typeface="ＭＳ Ｐゴシック"/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  <a:latin typeface="Arial"/>
              <a:ea typeface="ＭＳ Ｐゴシック"/>
            </a:endParaRPr>
          </a:p>
        </p:txBody>
      </p:sp>
    </p:spTree>
    <p:extLst>
      <p:ext uri="{BB962C8B-B14F-4D97-AF65-F5344CB8AC3E}">
        <p14:creationId xmlns:p14="http://schemas.microsoft.com/office/powerpoint/2010/main" val="3347601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6286" r:id="rId1"/>
    <p:sldLayoutId id="2147486287" r:id="rId2"/>
    <p:sldLayoutId id="2147486288" r:id="rId3"/>
    <p:sldLayoutId id="2147486289" r:id="rId4"/>
    <p:sldLayoutId id="2147486290" r:id="rId5"/>
    <p:sldLayoutId id="2147486291" r:id="rId6"/>
    <p:sldLayoutId id="2147486292" r:id="rId7"/>
    <p:sldLayoutId id="2147486293" r:id="rId8"/>
    <p:sldLayoutId id="2147486294" r:id="rId9"/>
    <p:sldLayoutId id="2147486295" r:id="rId10"/>
    <p:sldLayoutId id="2147486296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 Box 9"/>
          <p:cNvSpPr txBox="1">
            <a:spLocks noChangeArrowheads="1"/>
          </p:cNvSpPr>
          <p:nvPr/>
        </p:nvSpPr>
        <p:spPr bwMode="auto">
          <a:xfrm>
            <a:off x="250825" y="44624"/>
            <a:ext cx="8642350" cy="707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lvl="0">
              <a:defRPr/>
            </a:pPr>
            <a:r>
              <a:rPr lang="en-US" altLang="ja-JP" sz="2000" dirty="0">
                <a:solidFill>
                  <a:srgbClr val="000000"/>
                </a:solidFill>
                <a:latin typeface="Arial"/>
              </a:rPr>
              <a:t>Supplemental Figure 4</a:t>
            </a:r>
            <a:br>
              <a:rPr lang="en-US" altLang="ja-JP" sz="2000" dirty="0">
                <a:solidFill>
                  <a:srgbClr val="000000"/>
                </a:solidFill>
                <a:latin typeface="Arial"/>
              </a:rPr>
            </a:br>
            <a:r>
              <a:rPr lang="en-US" altLang="ja-JP" sz="2000" dirty="0">
                <a:solidFill>
                  <a:sysClr val="windowText" lastClr="000000"/>
                </a:solidFill>
                <a:cs typeface="Arial" panose="020B0604020202020204" pitchFamily="34" charset="0"/>
              </a:rPr>
              <a:t>Annual trend of average body mass index (BMI) by age group (1947-2017)</a:t>
            </a:r>
            <a:endParaRPr lang="ja-JP" altLang="en-US" sz="2000" dirty="0">
              <a:solidFill>
                <a:sysClr val="windowText" lastClr="000000"/>
              </a:solidFill>
              <a:cs typeface="Arial" panose="020B0604020202020204" pitchFamily="34" charset="0"/>
            </a:endParaRPr>
          </a:p>
        </p:txBody>
      </p:sp>
      <p:graphicFrame>
        <p:nvGraphicFramePr>
          <p:cNvPr id="18" name="コンテンツ プレースホルダー 17"/>
          <p:cNvGraphicFramePr>
            <a:graphicFrameLocks noGrp="1"/>
          </p:cNvGraphicFramePr>
          <p:nvPr>
            <p:ph sz="half" idx="1"/>
            <p:extLst/>
          </p:nvPr>
        </p:nvGraphicFramePr>
        <p:xfrm>
          <a:off x="457200" y="1052736"/>
          <a:ext cx="4038600" cy="50734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9" name="コンテンツ プレースホルダー 17"/>
          <p:cNvGraphicFramePr>
            <a:graphicFrameLocks noGrp="1"/>
          </p:cNvGraphicFramePr>
          <p:nvPr>
            <p:ph sz="half" idx="4294967295"/>
            <p:extLst/>
          </p:nvPr>
        </p:nvGraphicFramePr>
        <p:xfrm>
          <a:off x="4572000" y="1052736"/>
          <a:ext cx="4038600" cy="50734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Text Box 3">
            <a:extLst>
              <a:ext uri="{FF2B5EF4-FFF2-40B4-BE49-F238E27FC236}">
                <a16:creationId xmlns:a16="http://schemas.microsoft.com/office/drawing/2014/main" id="{6A512AB7-73B6-4179-AFD7-C7E23EE75E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91680" y="6237312"/>
            <a:ext cx="7284453" cy="5232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91422" tIns="45712" rIns="91422" bIns="45712"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Book Antiqua" pitchFamily="18" charset="0"/>
                <a:ea typeface="ＭＳ Ｐゴシック" charset="-128"/>
                <a:cs typeface="+mn-cs"/>
              </a:rPr>
              <a:t>“National Health and Nutrition Survey”, Ministry of Health, 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Book Antiqua" pitchFamily="18" charset="0"/>
                <a:ea typeface="ＭＳ Ｐゴシック" charset="-128"/>
                <a:cs typeface="+mn-cs"/>
              </a:rPr>
              <a:t>Labour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Book Antiqua" pitchFamily="18" charset="0"/>
                <a:ea typeface="ＭＳ Ｐゴシック" charset="-128"/>
                <a:cs typeface="+mn-cs"/>
              </a:rPr>
              <a:t> and Welfare</a:t>
            </a:r>
          </a:p>
          <a:p>
            <a:pPr lvl="0" algn="r">
              <a:defRPr/>
            </a:pPr>
            <a:r>
              <a:rPr lang="en-US" altLang="ja-JP" sz="1400" dirty="0">
                <a:solidFill>
                  <a:srgbClr val="000000"/>
                </a:solidFill>
                <a:latin typeface="Book Antiqua" pitchFamily="18" charset="0"/>
                <a:ea typeface="ＭＳ Ｐゴシック" charset="-128"/>
              </a:rPr>
              <a:t>https://www.mhlw.go.jp/bunya/kenkou/kenkou_eiyou_chousa.html</a:t>
            </a:r>
            <a:endParaRPr kumimoji="1" lang="ja-JP" altLang="en-US" sz="1400" b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Book Antiqua" pitchFamily="18" charset="0"/>
              <a:ea typeface="ＭＳ Ｐゴシック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615722116"/>
      </p:ext>
    </p:extLst>
  </p:cSld>
  <p:clrMapOvr>
    <a:masterClrMapping/>
  </p:clrMapOvr>
  <p:transition/>
</p:sld>
</file>

<file path=ppt/theme/theme1.xml><?xml version="1.0" encoding="utf-8"?>
<a:theme xmlns:a="http://schemas.openxmlformats.org/drawingml/2006/main" name="originalest_06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3">
      <a:majorFont>
        <a:latin typeface="Tahoma"/>
        <a:ea typeface="メイリオ"/>
        <a:cs typeface=""/>
      </a:majorFont>
      <a:minorFont>
        <a:latin typeface="Tahoma"/>
        <a:ea typeface="メイリオ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22_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08</TotalTime>
  <Words>57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Ｐゴシック</vt:lpstr>
      <vt:lpstr>ＭＳ Ｐ明朝</vt:lpstr>
      <vt:lpstr>メイリオ</vt:lpstr>
      <vt:lpstr>Arial</vt:lpstr>
      <vt:lpstr>Book Antiqua</vt:lpstr>
      <vt:lpstr>Tahoma</vt:lpstr>
      <vt:lpstr>Times New Roman</vt:lpstr>
      <vt:lpstr>originalest_06</vt:lpstr>
      <vt:lpstr>22_標準デザイン</vt:lpstr>
      <vt:lpstr>PowerPoint プレゼンテーション</vt:lpstr>
    </vt:vector>
  </TitlesOfParts>
  <Company>臨床疫学研究部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がん死亡者数の年次推移</dc:title>
  <dc:creator>kohashi</dc:creator>
  <cp:lastModifiedBy>Tsugane Shoi</cp:lastModifiedBy>
  <cp:revision>836</cp:revision>
  <cp:lastPrinted>2020-05-11T09:24:42Z</cp:lastPrinted>
  <dcterms:created xsi:type="dcterms:W3CDTF">2002-10-31T01:02:46Z</dcterms:created>
  <dcterms:modified xsi:type="dcterms:W3CDTF">2020-05-15T07:55:10Z</dcterms:modified>
</cp:coreProperties>
</file>